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56" r:id="rId2"/>
    <p:sldId id="257" r:id="rId3"/>
    <p:sldId id="282" r:id="rId4"/>
    <p:sldId id="283" r:id="rId5"/>
    <p:sldId id="281" r:id="rId6"/>
  </p:sldIdLst>
  <p:sldSz cx="6858000" cy="9906000" type="A4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87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2D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718" autoAdjust="0"/>
    <p:restoredTop sz="94660"/>
  </p:normalViewPr>
  <p:slideViewPr>
    <p:cSldViewPr snapToGrid="0">
      <p:cViewPr>
        <p:scale>
          <a:sx n="70" d="100"/>
          <a:sy n="70" d="100"/>
        </p:scale>
        <p:origin x="2587" y="-686"/>
      </p:cViewPr>
      <p:guideLst>
        <p:guide orient="horz" pos="3687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9.xlsx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0.xlsx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1.xlsx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2.xlsx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3.xlsx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4.xlsx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5.xlsx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6.xlsx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7.xlsx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8.xlsx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6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7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8.xlsx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OD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bg1">
                  <a:lumMod val="50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C$2:$C$13</c:f>
                <c:numCache>
                  <c:formatCode>General</c:formatCode>
                  <c:ptCount val="12"/>
                  <c:pt idx="0">
                    <c:v>1.0768577344729515E-2</c:v>
                  </c:pt>
                  <c:pt idx="1">
                    <c:v>1.5987191216834399E-2</c:v>
                  </c:pt>
                  <c:pt idx="2">
                    <c:v>2.081065916998982E-2</c:v>
                  </c:pt>
                  <c:pt idx="3">
                    <c:v>2.7988156171356221E-2</c:v>
                  </c:pt>
                  <c:pt idx="4">
                    <c:v>0.10167205614858024</c:v>
                  </c:pt>
                  <c:pt idx="5">
                    <c:v>4.6939140411377839E-2</c:v>
                  </c:pt>
                  <c:pt idx="6">
                    <c:v>0.18518656236261052</c:v>
                  </c:pt>
                  <c:pt idx="7">
                    <c:v>0.21109304247257085</c:v>
                  </c:pt>
                  <c:pt idx="8">
                    <c:v>0.10974292140360913</c:v>
                  </c:pt>
                  <c:pt idx="9">
                    <c:v>0.17741327469092588</c:v>
                  </c:pt>
                  <c:pt idx="10">
                    <c:v>0.13597817366752973</c:v>
                  </c:pt>
                </c:numCache>
              </c:numRef>
            </c:plus>
            <c:minus>
              <c:numRef>
                <c:f>Sheet1!$C$2:$C$13</c:f>
                <c:numCache>
                  <c:formatCode>General</c:formatCode>
                  <c:ptCount val="12"/>
                  <c:pt idx="0">
                    <c:v>1.0768577344729515E-2</c:v>
                  </c:pt>
                  <c:pt idx="1">
                    <c:v>1.5987191216834399E-2</c:v>
                  </c:pt>
                  <c:pt idx="2">
                    <c:v>2.081065916998982E-2</c:v>
                  </c:pt>
                  <c:pt idx="3">
                    <c:v>2.7988156171356221E-2</c:v>
                  </c:pt>
                  <c:pt idx="4">
                    <c:v>0.10167205614858024</c:v>
                  </c:pt>
                  <c:pt idx="5">
                    <c:v>4.6939140411377839E-2</c:v>
                  </c:pt>
                  <c:pt idx="6">
                    <c:v>0.18518656236261052</c:v>
                  </c:pt>
                  <c:pt idx="7">
                    <c:v>0.21109304247257085</c:v>
                  </c:pt>
                  <c:pt idx="8">
                    <c:v>0.10974292140360913</c:v>
                  </c:pt>
                  <c:pt idx="9">
                    <c:v>0.17741327469092588</c:v>
                  </c:pt>
                  <c:pt idx="10">
                    <c:v>0.1359781736675297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Sheet1!$A$2:$A$13</c:f>
              <c:numCache>
                <c:formatCode>General</c:formatCode>
                <c:ptCount val="12"/>
                <c:pt idx="0">
                  <c:v>0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22</c:v>
                </c:pt>
                <c:pt idx="9">
                  <c:v>43</c:v>
                </c:pt>
                <c:pt idx="10">
                  <c:v>58</c:v>
                </c:pt>
              </c:numCache>
            </c:numRef>
          </c:xVal>
          <c:yVal>
            <c:numRef>
              <c:f>Sheet1!$B$2:$B$13</c:f>
              <c:numCache>
                <c:formatCode>General</c:formatCode>
                <c:ptCount val="12"/>
                <c:pt idx="0">
                  <c:v>-8.8817728982409732E-4</c:v>
                </c:pt>
                <c:pt idx="1">
                  <c:v>2.3980786825251611E-2</c:v>
                </c:pt>
                <c:pt idx="2">
                  <c:v>3.7303446172613622E-2</c:v>
                </c:pt>
                <c:pt idx="3">
                  <c:v>8.3488665243468471E-2</c:v>
                </c:pt>
                <c:pt idx="4">
                  <c:v>0.33306648368405001</c:v>
                </c:pt>
                <c:pt idx="5">
                  <c:v>0.54178814679272136</c:v>
                </c:pt>
                <c:pt idx="6">
                  <c:v>1.5205595201789164</c:v>
                </c:pt>
                <c:pt idx="7">
                  <c:v>3.0304609128799433</c:v>
                </c:pt>
                <c:pt idx="8">
                  <c:v>4.4826307817424009</c:v>
                </c:pt>
                <c:pt idx="9">
                  <c:v>6.6631060282606489</c:v>
                </c:pt>
                <c:pt idx="10">
                  <c:v>6.731495679577107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F2A-40D2-B37B-206C571A745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94614576"/>
        <c:axId val="894615120"/>
      </c:scatterChart>
      <c:valAx>
        <c:axId val="894614576"/>
        <c:scaling>
          <c:orientation val="minMax"/>
          <c:max val="8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Cultivation time (h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94615120"/>
        <c:crosses val="autoZero"/>
        <c:crossBetween val="midCat"/>
        <c:majorUnit val="12"/>
      </c:valAx>
      <c:valAx>
        <c:axId val="894615120"/>
        <c:scaling>
          <c:orientation val="minMax"/>
          <c:max val="8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OD</a:t>
                </a:r>
                <a:r>
                  <a:rPr lang="en-US" baseline="-25000" dirty="0"/>
                  <a:t>600</a:t>
                </a:r>
                <a:endParaRPr lang="ja-JP" baseline="-2500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94614576"/>
        <c:crosses val="autoZero"/>
        <c:crossBetween val="midCat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OD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bg1">
                  <a:lumMod val="50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C$2:$C$13</c:f>
                <c:numCache>
                  <c:formatCode>General</c:formatCode>
                  <c:ptCount val="12"/>
                  <c:pt idx="0">
                    <c:v>5.0389079107137164E-2</c:v>
                  </c:pt>
                  <c:pt idx="1">
                    <c:v>1.8803593880217944E-2</c:v>
                  </c:pt>
                  <c:pt idx="2">
                    <c:v>3.2181810425346805E-2</c:v>
                  </c:pt>
                  <c:pt idx="3">
                    <c:v>1.804811847218463E-2</c:v>
                  </c:pt>
                  <c:pt idx="4">
                    <c:v>0.23185029206886956</c:v>
                  </c:pt>
                  <c:pt idx="5">
                    <c:v>0.41992114764386013</c:v>
                  </c:pt>
                  <c:pt idx="6">
                    <c:v>0.12017029470899512</c:v>
                  </c:pt>
                  <c:pt idx="7">
                    <c:v>0.14027725946427044</c:v>
                  </c:pt>
                  <c:pt idx="8">
                    <c:v>0.23850916377649417</c:v>
                  </c:pt>
                  <c:pt idx="9">
                    <c:v>2.7770192278853485E-2</c:v>
                  </c:pt>
                  <c:pt idx="10">
                    <c:v>0.16744620156749046</c:v>
                  </c:pt>
                  <c:pt idx="11">
                    <c:v>9.9708900517355648E-2</c:v>
                  </c:pt>
                </c:numCache>
              </c:numRef>
            </c:plus>
            <c:minus>
              <c:numRef>
                <c:f>Sheet1!$C$2:$C$13</c:f>
                <c:numCache>
                  <c:formatCode>General</c:formatCode>
                  <c:ptCount val="12"/>
                  <c:pt idx="0">
                    <c:v>5.0389079107137164E-2</c:v>
                  </c:pt>
                  <c:pt idx="1">
                    <c:v>1.8803593880217944E-2</c:v>
                  </c:pt>
                  <c:pt idx="2">
                    <c:v>3.2181810425346805E-2</c:v>
                  </c:pt>
                  <c:pt idx="3">
                    <c:v>1.804811847218463E-2</c:v>
                  </c:pt>
                  <c:pt idx="4">
                    <c:v>0.23185029206886956</c:v>
                  </c:pt>
                  <c:pt idx="5">
                    <c:v>0.41992114764386013</c:v>
                  </c:pt>
                  <c:pt idx="6">
                    <c:v>0.12017029470899512</c:v>
                  </c:pt>
                  <c:pt idx="7">
                    <c:v>0.14027725946427044</c:v>
                  </c:pt>
                  <c:pt idx="8">
                    <c:v>0.23850916377649417</c:v>
                  </c:pt>
                  <c:pt idx="9">
                    <c:v>2.7770192278853485E-2</c:v>
                  </c:pt>
                  <c:pt idx="10">
                    <c:v>0.16744620156749046</c:v>
                  </c:pt>
                  <c:pt idx="11">
                    <c:v>9.9708900517355648E-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Sheet1!$A$2:$A$13</c:f>
              <c:numCache>
                <c:formatCode>General</c:formatCode>
                <c:ptCount val="12"/>
                <c:pt idx="0">
                  <c:v>0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9</c:v>
                </c:pt>
                <c:pt idx="9">
                  <c:v>22</c:v>
                </c:pt>
                <c:pt idx="10">
                  <c:v>43</c:v>
                </c:pt>
                <c:pt idx="11">
                  <c:v>58</c:v>
                </c:pt>
              </c:numCache>
            </c:numRef>
          </c:xVal>
          <c:yVal>
            <c:numRef>
              <c:f>Sheet1!$B$2:$B$13</c:f>
              <c:numCache>
                <c:formatCode>General</c:formatCode>
                <c:ptCount val="12"/>
                <c:pt idx="0">
                  <c:v>4.9130202140309089E-2</c:v>
                </c:pt>
                <c:pt idx="1">
                  <c:v>1.3486722156163351E-2</c:v>
                </c:pt>
                <c:pt idx="2">
                  <c:v>8.6700356718192439E-3</c:v>
                </c:pt>
                <c:pt idx="3">
                  <c:v>6.3580261593341222E-2</c:v>
                </c:pt>
                <c:pt idx="4">
                  <c:v>0.69071284185493453</c:v>
                </c:pt>
                <c:pt idx="5">
                  <c:v>2.0586518034086407</c:v>
                </c:pt>
                <c:pt idx="6">
                  <c:v>3.2368133174791911</c:v>
                </c:pt>
                <c:pt idx="7">
                  <c:v>3.485354340071344</c:v>
                </c:pt>
                <c:pt idx="8">
                  <c:v>3.4709042806183112</c:v>
                </c:pt>
                <c:pt idx="9">
                  <c:v>3.2618600871977805</c:v>
                </c:pt>
                <c:pt idx="10">
                  <c:v>3.6327449464922714</c:v>
                </c:pt>
                <c:pt idx="11">
                  <c:v>3.64526833135156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CD7-499C-9D4F-4D61CEA58B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15624496"/>
        <c:axId val="1315639728"/>
      </c:scatterChart>
      <c:valAx>
        <c:axId val="1315624496"/>
        <c:scaling>
          <c:orientation val="minMax"/>
          <c:max val="8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Cultivation time (h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15639728"/>
        <c:crosses val="autoZero"/>
        <c:crossBetween val="midCat"/>
        <c:majorUnit val="12"/>
      </c:valAx>
      <c:valAx>
        <c:axId val="1315639728"/>
        <c:scaling>
          <c:orientation val="minMax"/>
          <c:max val="8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OD</a:t>
                </a:r>
                <a:r>
                  <a:rPr lang="en-US" baseline="-25000" dirty="0"/>
                  <a:t>600</a:t>
                </a:r>
                <a:endParaRPr lang="ja-JP" baseline="-2500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15624496"/>
        <c:crosses val="autoZero"/>
        <c:crossBetween val="midCat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OD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bg1">
                  <a:lumMod val="50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C$2:$C$13</c:f>
                <c:numCache>
                  <c:formatCode>General</c:formatCode>
                  <c:ptCount val="12"/>
                  <c:pt idx="0">
                    <c:v>2.8111057043309746E-2</c:v>
                  </c:pt>
                  <c:pt idx="1">
                    <c:v>1.2530629991834486E-2</c:v>
                  </c:pt>
                  <c:pt idx="2">
                    <c:v>2.8923421672932579E-2</c:v>
                  </c:pt>
                  <c:pt idx="3">
                    <c:v>4.3079992701801392E-2</c:v>
                  </c:pt>
                  <c:pt idx="4">
                    <c:v>0.2385787845120122</c:v>
                  </c:pt>
                  <c:pt idx="5">
                    <c:v>0.16313504097114179</c:v>
                  </c:pt>
                  <c:pt idx="6">
                    <c:v>6.8200422478623235E-2</c:v>
                  </c:pt>
                  <c:pt idx="7">
                    <c:v>0.17026878254433273</c:v>
                  </c:pt>
                  <c:pt idx="8">
                    <c:v>2.5214854434744916E-2</c:v>
                  </c:pt>
                  <c:pt idx="9">
                    <c:v>4.9398317522398989E-2</c:v>
                  </c:pt>
                  <c:pt idx="10">
                    <c:v>0.10880270519150954</c:v>
                  </c:pt>
                </c:numCache>
              </c:numRef>
            </c:plus>
            <c:minus>
              <c:numRef>
                <c:f>Sheet1!$C$2:$C$13</c:f>
                <c:numCache>
                  <c:formatCode>General</c:formatCode>
                  <c:ptCount val="12"/>
                  <c:pt idx="0">
                    <c:v>2.8111057043309746E-2</c:v>
                  </c:pt>
                  <c:pt idx="1">
                    <c:v>1.2530629991834486E-2</c:v>
                  </c:pt>
                  <c:pt idx="2">
                    <c:v>2.8923421672932579E-2</c:v>
                  </c:pt>
                  <c:pt idx="3">
                    <c:v>4.3079992701801392E-2</c:v>
                  </c:pt>
                  <c:pt idx="4">
                    <c:v>0.2385787845120122</c:v>
                  </c:pt>
                  <c:pt idx="5">
                    <c:v>0.16313504097114179</c:v>
                  </c:pt>
                  <c:pt idx="6">
                    <c:v>6.8200422478623235E-2</c:v>
                  </c:pt>
                  <c:pt idx="7">
                    <c:v>0.17026878254433273</c:v>
                  </c:pt>
                  <c:pt idx="8">
                    <c:v>2.5214854434744916E-2</c:v>
                  </c:pt>
                  <c:pt idx="9">
                    <c:v>4.9398317522398989E-2</c:v>
                  </c:pt>
                  <c:pt idx="10">
                    <c:v>0.10880270519150954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Sheet1!$A$2:$A$13</c:f>
              <c:numCache>
                <c:formatCode>General</c:formatCode>
                <c:ptCount val="12"/>
                <c:pt idx="0">
                  <c:v>0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22</c:v>
                </c:pt>
                <c:pt idx="9">
                  <c:v>43</c:v>
                </c:pt>
                <c:pt idx="10">
                  <c:v>58</c:v>
                </c:pt>
              </c:numCache>
            </c:numRef>
          </c:xVal>
          <c:yVal>
            <c:numRef>
              <c:f>Sheet1!$B$2:$B$13</c:f>
              <c:numCache>
                <c:formatCode>General</c:formatCode>
                <c:ptCount val="12"/>
                <c:pt idx="0">
                  <c:v>-3.705163291370165E-3</c:v>
                </c:pt>
                <c:pt idx="1">
                  <c:v>4.6314541142127392E-3</c:v>
                </c:pt>
                <c:pt idx="2">
                  <c:v>3.7051632913702288E-3</c:v>
                </c:pt>
                <c:pt idx="3">
                  <c:v>0.1546905674147053</c:v>
                </c:pt>
                <c:pt idx="4">
                  <c:v>1.3449742747673781</c:v>
                </c:pt>
                <c:pt idx="5">
                  <c:v>2.479680532749498</c:v>
                </c:pt>
                <c:pt idx="6">
                  <c:v>3.2410915891260714</c:v>
                </c:pt>
                <c:pt idx="7">
                  <c:v>3.4161605546433136</c:v>
                </c:pt>
                <c:pt idx="8">
                  <c:v>3.2920375843824119</c:v>
                </c:pt>
                <c:pt idx="9">
                  <c:v>3.5513990147783248</c:v>
                </c:pt>
                <c:pt idx="10">
                  <c:v>3.448580733442802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A0B-4AC0-9E34-E9064559EF9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15633200"/>
        <c:axId val="1315637008"/>
      </c:scatterChart>
      <c:valAx>
        <c:axId val="1315633200"/>
        <c:scaling>
          <c:orientation val="minMax"/>
          <c:max val="8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Cultivation time (h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15637008"/>
        <c:crosses val="autoZero"/>
        <c:crossBetween val="midCat"/>
        <c:majorUnit val="12"/>
      </c:valAx>
      <c:valAx>
        <c:axId val="1315637008"/>
        <c:scaling>
          <c:orientation val="minMax"/>
          <c:max val="8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OD</a:t>
                </a:r>
                <a:r>
                  <a:rPr lang="en-US" baseline="-25000" dirty="0"/>
                  <a:t>600</a:t>
                </a:r>
                <a:endParaRPr lang="ja-JP" baseline="-2500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15633200"/>
        <c:crosses val="autoZero"/>
        <c:crossBetween val="midCat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763916752483974"/>
          <c:y val="8.4589832945165214E-2"/>
          <c:w val="0.73236083247516026"/>
          <c:h val="0.7665650291485710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列1</c:v>
                </c:pt>
              </c:strCache>
            </c:strRef>
          </c:tx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3:$C$5</c:f>
                <c:numCache>
                  <c:formatCode>General</c:formatCode>
                  <c:ptCount val="3"/>
                  <c:pt idx="0">
                    <c:v>0.13914378325557678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plus>
            <c:minus>
              <c:numRef>
                <c:f>Sheet1!$C$3:$C$5</c:f>
                <c:numCache>
                  <c:formatCode>General</c:formatCode>
                  <c:ptCount val="3"/>
                  <c:pt idx="0">
                    <c:v>0.13914378325557678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B$3:$B$5</c:f>
              <c:numCache>
                <c:formatCode>General</c:formatCode>
                <c:ptCount val="3"/>
                <c:pt idx="0">
                  <c:v>5.005130059825583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46B-4BD8-97D6-1F72B1CAC3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89679743"/>
        <c:axId val="789680991"/>
      </c:barChart>
      <c:catAx>
        <c:axId val="7896797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noFill/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789680991"/>
        <c:crosses val="autoZero"/>
        <c:auto val="1"/>
        <c:lblAlgn val="ctr"/>
        <c:lblOffset val="100"/>
        <c:noMultiLvlLbl val="0"/>
      </c:catAx>
      <c:valAx>
        <c:axId val="789680991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7896797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aseline="0">
          <a:solidFill>
            <a:schemeClr val="tx1"/>
          </a:solidFill>
          <a:latin typeface="Calibri" panose="020F0502020204030204" pitchFamily="34" charset="0"/>
        </a:defRPr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763916752483974"/>
          <c:y val="8.4589832945165214E-2"/>
          <c:w val="0.73236083247516026"/>
          <c:h val="0.7665650291485710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列1</c:v>
                </c:pt>
              </c:strCache>
            </c:strRef>
          </c:tx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3:$C$5</c:f>
                <c:numCache>
                  <c:formatCode>General</c:formatCode>
                  <c:ptCount val="3"/>
                  <c:pt idx="0">
                    <c:v>0.12265161361336922</c:v>
                  </c:pt>
                  <c:pt idx="1">
                    <c:v>0.168969286447057</c:v>
                  </c:pt>
                  <c:pt idx="2">
                    <c:v>0.12169410584322037</c:v>
                  </c:pt>
                </c:numCache>
              </c:numRef>
            </c:plus>
            <c:minus>
              <c:numRef>
                <c:f>Sheet1!$C$3:$C$5</c:f>
                <c:numCache>
                  <c:formatCode>General</c:formatCode>
                  <c:ptCount val="3"/>
                  <c:pt idx="0">
                    <c:v>0.12265161361336922</c:v>
                  </c:pt>
                  <c:pt idx="1">
                    <c:v>0.168969286447057</c:v>
                  </c:pt>
                  <c:pt idx="2">
                    <c:v>0.1216941058432203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B$3:$B$5</c:f>
              <c:numCache>
                <c:formatCode>General</c:formatCode>
                <c:ptCount val="3"/>
                <c:pt idx="0">
                  <c:v>14.031167459059693</c:v>
                </c:pt>
                <c:pt idx="1">
                  <c:v>2.7182360256314788</c:v>
                </c:pt>
                <c:pt idx="2">
                  <c:v>0.348558336264674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295-443C-80D2-086F0424803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89679743"/>
        <c:axId val="789680991"/>
      </c:barChart>
      <c:catAx>
        <c:axId val="7896797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noFill/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789680991"/>
        <c:crosses val="autoZero"/>
        <c:auto val="1"/>
        <c:lblAlgn val="ctr"/>
        <c:lblOffset val="100"/>
        <c:noMultiLvlLbl val="0"/>
      </c:catAx>
      <c:valAx>
        <c:axId val="789680991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7896797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aseline="0">
          <a:solidFill>
            <a:schemeClr val="tx1"/>
          </a:solidFill>
          <a:latin typeface="Calibri" panose="020F0502020204030204" pitchFamily="34" charset="0"/>
        </a:defRPr>
      </a:pPr>
      <a:endParaRPr lang="en-U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763916752483974"/>
          <c:y val="8.4589832945165214E-2"/>
          <c:w val="0.73236083247516026"/>
          <c:h val="0.7665650291485710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列1</c:v>
                </c:pt>
              </c:strCache>
            </c:strRef>
          </c:tx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3:$C$5</c:f>
                <c:numCache>
                  <c:formatCode>General</c:formatCode>
                  <c:ptCount val="3"/>
                  <c:pt idx="0">
                    <c:v>6.7768662553064504E-2</c:v>
                  </c:pt>
                  <c:pt idx="1">
                    <c:v>5.6486779031882442E-3</c:v>
                  </c:pt>
                  <c:pt idx="2">
                    <c:v>0.48301831122549432</c:v>
                  </c:pt>
                </c:numCache>
              </c:numRef>
            </c:plus>
            <c:minus>
              <c:numRef>
                <c:f>Sheet1!$C$3:$C$5</c:f>
                <c:numCache>
                  <c:formatCode>General</c:formatCode>
                  <c:ptCount val="3"/>
                  <c:pt idx="0">
                    <c:v>6.7768662553064504E-2</c:v>
                  </c:pt>
                  <c:pt idx="1">
                    <c:v>5.6486779031882442E-3</c:v>
                  </c:pt>
                  <c:pt idx="2">
                    <c:v>0.4830183112254943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B$3:$B$5</c:f>
              <c:numCache>
                <c:formatCode>General</c:formatCode>
                <c:ptCount val="3"/>
                <c:pt idx="0">
                  <c:v>2.7069606178577352</c:v>
                </c:pt>
                <c:pt idx="1">
                  <c:v>0.84645984564173826</c:v>
                </c:pt>
                <c:pt idx="2">
                  <c:v>0.278870752009557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72B-400F-97B2-DF43D648071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89679743"/>
        <c:axId val="789680991"/>
      </c:barChart>
      <c:catAx>
        <c:axId val="7896797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noFill/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789680991"/>
        <c:crosses val="autoZero"/>
        <c:auto val="1"/>
        <c:lblAlgn val="ctr"/>
        <c:lblOffset val="100"/>
        <c:noMultiLvlLbl val="0"/>
      </c:catAx>
      <c:valAx>
        <c:axId val="789680991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7896797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aseline="0">
          <a:solidFill>
            <a:schemeClr val="tx1"/>
          </a:solidFill>
          <a:latin typeface="Calibri" panose="020F0502020204030204" pitchFamily="34" charset="0"/>
        </a:defRPr>
      </a:pPr>
      <a:endParaRPr lang="en-US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763916752483974"/>
          <c:y val="8.4589832945165214E-2"/>
          <c:w val="0.73236083247516026"/>
          <c:h val="0.7665650291485710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列1</c:v>
                </c:pt>
              </c:strCache>
            </c:strRef>
          </c:tx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3:$C$4</c:f>
                <c:numCache>
                  <c:formatCode>General</c:formatCode>
                  <c:ptCount val="2"/>
                  <c:pt idx="0">
                    <c:v>4.6820015255563936</c:v>
                  </c:pt>
                  <c:pt idx="1">
                    <c:v>0.40681008243726507</c:v>
                  </c:pt>
                </c:numCache>
              </c:numRef>
            </c:plus>
            <c:minus>
              <c:numRef>
                <c:f>Sheet1!$C$3:$C$4</c:f>
                <c:numCache>
                  <c:formatCode>General</c:formatCode>
                  <c:ptCount val="2"/>
                  <c:pt idx="0">
                    <c:v>4.6820015255563936</c:v>
                  </c:pt>
                  <c:pt idx="1">
                    <c:v>0.4068100824372650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B$3:$B$4</c:f>
              <c:numCache>
                <c:formatCode>General</c:formatCode>
                <c:ptCount val="2"/>
                <c:pt idx="0">
                  <c:v>22.637096528593489</c:v>
                </c:pt>
                <c:pt idx="1">
                  <c:v>0.911686613391399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ECE-4453-9D8F-013E0CFFDB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89679743"/>
        <c:axId val="789680991"/>
      </c:barChart>
      <c:catAx>
        <c:axId val="7896797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noFill/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789680991"/>
        <c:crosses val="autoZero"/>
        <c:auto val="1"/>
        <c:lblAlgn val="ctr"/>
        <c:lblOffset val="100"/>
        <c:noMultiLvlLbl val="0"/>
      </c:catAx>
      <c:valAx>
        <c:axId val="789680991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7896797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aseline="0">
          <a:solidFill>
            <a:schemeClr val="tx1"/>
          </a:solidFill>
          <a:latin typeface="Calibri" panose="020F0502020204030204" pitchFamily="34" charset="0"/>
        </a:defRPr>
      </a:pPr>
      <a:endParaRPr lang="en-US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763916752483974"/>
          <c:y val="8.4589832945165214E-2"/>
          <c:w val="0.73236083247516026"/>
          <c:h val="0.7665650291485710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列1</c:v>
                </c:pt>
              </c:strCache>
            </c:strRef>
          </c:tx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3:$C$4</c:f>
                <c:numCache>
                  <c:formatCode>General</c:formatCode>
                  <c:ptCount val="2"/>
                  <c:pt idx="0">
                    <c:v>7.2492278099318984E-7</c:v>
                  </c:pt>
                  <c:pt idx="1">
                    <c:v>0.45916461780501999</c:v>
                  </c:pt>
                </c:numCache>
              </c:numRef>
            </c:plus>
            <c:minus>
              <c:numRef>
                <c:f>Sheet1!$C$3:$C$4</c:f>
                <c:numCache>
                  <c:formatCode>General</c:formatCode>
                  <c:ptCount val="2"/>
                  <c:pt idx="0">
                    <c:v>7.2492278099318984E-7</c:v>
                  </c:pt>
                  <c:pt idx="1">
                    <c:v>0.459164617805019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B$3:$B$4</c:f>
              <c:numCache>
                <c:formatCode>General</c:formatCode>
                <c:ptCount val="2"/>
                <c:pt idx="0">
                  <c:v>0.79529546448158384</c:v>
                </c:pt>
                <c:pt idx="1">
                  <c:v>0.265098815692079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F32-4E29-A9CC-66C5FF9EB2A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89679743"/>
        <c:axId val="789680991"/>
      </c:barChart>
      <c:catAx>
        <c:axId val="7896797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noFill/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789680991"/>
        <c:crosses val="autoZero"/>
        <c:auto val="1"/>
        <c:lblAlgn val="ctr"/>
        <c:lblOffset val="100"/>
        <c:noMultiLvlLbl val="0"/>
      </c:catAx>
      <c:valAx>
        <c:axId val="789680991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7896797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aseline="0">
          <a:solidFill>
            <a:schemeClr val="tx1"/>
          </a:solidFill>
          <a:latin typeface="Calibri" panose="020F0502020204030204" pitchFamily="34" charset="0"/>
        </a:defRPr>
      </a:pPr>
      <a:endParaRPr lang="en-US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763916752483974"/>
          <c:y val="8.4589832945165214E-2"/>
          <c:w val="0.73236083247516026"/>
          <c:h val="0.7665650291485710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列1</c:v>
                </c:pt>
              </c:strCache>
            </c:strRef>
          </c:tx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3:$C$4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</c:v>
                  </c:pt>
                </c:numCache>
              </c:numRef>
            </c:plus>
            <c:minus>
              <c:numRef>
                <c:f>Sheet1!$C$3:$C$4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B$3:$B$4</c:f>
              <c:numCache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802-4AD8-8E5E-1F64DB0FED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89679743"/>
        <c:axId val="789680991"/>
      </c:barChart>
      <c:catAx>
        <c:axId val="7896797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noFill/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789680991"/>
        <c:crosses val="autoZero"/>
        <c:auto val="1"/>
        <c:lblAlgn val="ctr"/>
        <c:lblOffset val="100"/>
        <c:noMultiLvlLbl val="0"/>
      </c:catAx>
      <c:valAx>
        <c:axId val="789680991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7896797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aseline="0">
          <a:solidFill>
            <a:schemeClr val="tx1"/>
          </a:solidFill>
          <a:latin typeface="Calibri" panose="020F0502020204030204" pitchFamily="34" charset="0"/>
        </a:defRPr>
      </a:pPr>
      <a:endParaRPr lang="en-US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OD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bg1">
                  <a:lumMod val="50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C$2:$C$7</c:f>
                <c:numCache>
                  <c:formatCode>General</c:formatCode>
                  <c:ptCount val="6"/>
                  <c:pt idx="0">
                    <c:v>0.1216878572022336</c:v>
                  </c:pt>
                  <c:pt idx="1">
                    <c:v>0.16926838800989361</c:v>
                  </c:pt>
                  <c:pt idx="2">
                    <c:v>0.11311328427512594</c:v>
                  </c:pt>
                  <c:pt idx="3">
                    <c:v>0.10594961405066079</c:v>
                  </c:pt>
                  <c:pt idx="4">
                    <c:v>4.0223807034103866E-2</c:v>
                  </c:pt>
                  <c:pt idx="5">
                    <c:v>2.1429687110673269E-2</c:v>
                  </c:pt>
                </c:numCache>
              </c:numRef>
            </c:plus>
            <c:minus>
              <c:numRef>
                <c:f>Sheet1!$C$2:$C$7</c:f>
                <c:numCache>
                  <c:formatCode>General</c:formatCode>
                  <c:ptCount val="6"/>
                  <c:pt idx="0">
                    <c:v>0.1216878572022336</c:v>
                  </c:pt>
                  <c:pt idx="1">
                    <c:v>0.16926838800989361</c:v>
                  </c:pt>
                  <c:pt idx="2">
                    <c:v>0.11311328427512594</c:v>
                  </c:pt>
                  <c:pt idx="3">
                    <c:v>0.10594961405066079</c:v>
                  </c:pt>
                  <c:pt idx="4">
                    <c:v>4.0223807034103866E-2</c:v>
                  </c:pt>
                  <c:pt idx="5">
                    <c:v>2.1429687110673269E-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Sheet1!$A$2:$A$7</c:f>
              <c:numCache>
                <c:formatCode>General</c:formatCode>
                <c:ptCount val="6"/>
                <c:pt idx="0">
                  <c:v>0</c:v>
                </c:pt>
                <c:pt idx="1">
                  <c:v>250</c:v>
                </c:pt>
                <c:pt idx="2">
                  <c:v>500</c:v>
                </c:pt>
                <c:pt idx="3">
                  <c:v>750</c:v>
                </c:pt>
                <c:pt idx="4">
                  <c:v>1000</c:v>
                </c:pt>
                <c:pt idx="5">
                  <c:v>1200</c:v>
                </c:pt>
              </c:numCache>
            </c:numRef>
          </c:xVal>
          <c:yVal>
            <c:numRef>
              <c:f>Sheet1!$B$2:$B$7</c:f>
              <c:numCache>
                <c:formatCode>General</c:formatCode>
                <c:ptCount val="6"/>
                <c:pt idx="0">
                  <c:v>2.8091241431835496</c:v>
                </c:pt>
                <c:pt idx="1">
                  <c:v>4.1724051789794361</c:v>
                </c:pt>
                <c:pt idx="2">
                  <c:v>4.4110297029702972</c:v>
                </c:pt>
                <c:pt idx="3">
                  <c:v>3.964993145468394</c:v>
                </c:pt>
                <c:pt idx="4">
                  <c:v>2.3540258948971826</c:v>
                </c:pt>
                <c:pt idx="5">
                  <c:v>1.006854531606896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80D-43C0-9ADA-6FB9A5FED9E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15624496"/>
        <c:axId val="1315639728"/>
      </c:scatterChart>
      <c:valAx>
        <c:axId val="1315624496"/>
        <c:scaling>
          <c:orientation val="minMax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15639728"/>
        <c:crosses val="autoZero"/>
        <c:crossBetween val="midCat"/>
      </c:valAx>
      <c:valAx>
        <c:axId val="1315639728"/>
        <c:scaling>
          <c:orientation val="minMax"/>
          <c:max val="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15624496"/>
        <c:crosses val="autoZero"/>
        <c:crossBetween val="midCat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put濃度(mM)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bg1">
                  <a:lumMod val="50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C$2:$C$7</c:f>
                <c:numCache>
                  <c:formatCode>General</c:formatCode>
                  <c:ptCount val="6"/>
                  <c:pt idx="0">
                    <c:v>3.8429066452426272E-3</c:v>
                  </c:pt>
                  <c:pt idx="1">
                    <c:v>1.0261044700986763</c:v>
                  </c:pt>
                  <c:pt idx="2">
                    <c:v>2.0437783219954264</c:v>
                  </c:pt>
                  <c:pt idx="3">
                    <c:v>3.3103337071681556</c:v>
                  </c:pt>
                  <c:pt idx="4">
                    <c:v>2.4644538153461486</c:v>
                  </c:pt>
                  <c:pt idx="5">
                    <c:v>0.60533601858189323</c:v>
                  </c:pt>
                </c:numCache>
              </c:numRef>
            </c:plus>
            <c:minus>
              <c:numRef>
                <c:f>Sheet1!$C$2:$C$7</c:f>
                <c:numCache>
                  <c:formatCode>General</c:formatCode>
                  <c:ptCount val="6"/>
                  <c:pt idx="0">
                    <c:v>3.8429066452426272E-3</c:v>
                  </c:pt>
                  <c:pt idx="1">
                    <c:v>1.0261044700986763</c:v>
                  </c:pt>
                  <c:pt idx="2">
                    <c:v>2.0437783219954264</c:v>
                  </c:pt>
                  <c:pt idx="3">
                    <c:v>3.3103337071681556</c:v>
                  </c:pt>
                  <c:pt idx="4">
                    <c:v>2.4644538153461486</c:v>
                  </c:pt>
                  <c:pt idx="5">
                    <c:v>0.6053360185818932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Sheet1!$A$2:$A$7</c:f>
              <c:numCache>
                <c:formatCode>General</c:formatCode>
                <c:ptCount val="6"/>
                <c:pt idx="0">
                  <c:v>0</c:v>
                </c:pt>
                <c:pt idx="1">
                  <c:v>250</c:v>
                </c:pt>
                <c:pt idx="2">
                  <c:v>500</c:v>
                </c:pt>
                <c:pt idx="3">
                  <c:v>750</c:v>
                </c:pt>
                <c:pt idx="4">
                  <c:v>1000</c:v>
                </c:pt>
                <c:pt idx="5">
                  <c:v>1200</c:v>
                </c:pt>
              </c:numCache>
            </c:numRef>
          </c:xVal>
          <c:yVal>
            <c:numRef>
              <c:f>Sheet1!$B$2:$B$7</c:f>
              <c:numCache>
                <c:formatCode>General</c:formatCode>
                <c:ptCount val="6"/>
                <c:pt idx="0">
                  <c:v>0.14868205766315593</c:v>
                </c:pt>
                <c:pt idx="1">
                  <c:v>25.968087260086605</c:v>
                </c:pt>
                <c:pt idx="2">
                  <c:v>40.933374810513477</c:v>
                </c:pt>
                <c:pt idx="3">
                  <c:v>94.068225023577796</c:v>
                </c:pt>
                <c:pt idx="4">
                  <c:v>67.587983468381069</c:v>
                </c:pt>
                <c:pt idx="5">
                  <c:v>8.91322286993621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884-43DD-A92B-E791291A492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15624496"/>
        <c:axId val="1315639728"/>
      </c:scatterChart>
      <c:valAx>
        <c:axId val="1315624496"/>
        <c:scaling>
          <c:orientation val="minMax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15639728"/>
        <c:crosses val="autoZero"/>
        <c:crossBetween val="midCat"/>
      </c:valAx>
      <c:valAx>
        <c:axId val="1315639728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1562449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OD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bg1">
                  <a:lumMod val="50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C$2:$C$13</c:f>
                <c:numCache>
                  <c:formatCode>General</c:formatCode>
                  <c:ptCount val="12"/>
                  <c:pt idx="0">
                    <c:v>5.7226998978217369E-2</c:v>
                  </c:pt>
                  <c:pt idx="1">
                    <c:v>3.0935578366402705E-2</c:v>
                  </c:pt>
                  <c:pt idx="2">
                    <c:v>3.2198770829580385E-2</c:v>
                  </c:pt>
                  <c:pt idx="3">
                    <c:v>8.4553393683642453E-2</c:v>
                  </c:pt>
                  <c:pt idx="4">
                    <c:v>0.30174447208640387</c:v>
                  </c:pt>
                  <c:pt idx="5">
                    <c:v>0.27943015544421174</c:v>
                  </c:pt>
                  <c:pt idx="6">
                    <c:v>7.3308779647676861E-2</c:v>
                  </c:pt>
                  <c:pt idx="7">
                    <c:v>0.38465358189407522</c:v>
                  </c:pt>
                  <c:pt idx="8">
                    <c:v>7.8592816015542466E-2</c:v>
                  </c:pt>
                  <c:pt idx="9">
                    <c:v>0.51541248364178205</c:v>
                  </c:pt>
                  <c:pt idx="10">
                    <c:v>6.8857212519512379E-2</c:v>
                  </c:pt>
                  <c:pt idx="11">
                    <c:v>9.4059541604715094E-2</c:v>
                  </c:pt>
                </c:numCache>
              </c:numRef>
            </c:plus>
            <c:minus>
              <c:numRef>
                <c:f>Sheet1!$C$2:$C$13</c:f>
                <c:numCache>
                  <c:formatCode>General</c:formatCode>
                  <c:ptCount val="12"/>
                  <c:pt idx="0">
                    <c:v>5.7226998978217369E-2</c:v>
                  </c:pt>
                  <c:pt idx="1">
                    <c:v>3.0935578366402705E-2</c:v>
                  </c:pt>
                  <c:pt idx="2">
                    <c:v>3.2198770829580385E-2</c:v>
                  </c:pt>
                  <c:pt idx="3">
                    <c:v>8.4553393683642453E-2</c:v>
                  </c:pt>
                  <c:pt idx="4">
                    <c:v>0.30174447208640387</c:v>
                  </c:pt>
                  <c:pt idx="5">
                    <c:v>0.27943015544421174</c:v>
                  </c:pt>
                  <c:pt idx="6">
                    <c:v>7.3308779647676861E-2</c:v>
                  </c:pt>
                  <c:pt idx="7">
                    <c:v>0.38465358189407522</c:v>
                  </c:pt>
                  <c:pt idx="8">
                    <c:v>7.8592816015542466E-2</c:v>
                  </c:pt>
                  <c:pt idx="9">
                    <c:v>0.51541248364178205</c:v>
                  </c:pt>
                  <c:pt idx="10">
                    <c:v>6.8857212519512379E-2</c:v>
                  </c:pt>
                  <c:pt idx="11">
                    <c:v>9.4059541604715094E-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Sheet1!$A$2:$A$13</c:f>
              <c:numCache>
                <c:formatCode>General</c:formatCode>
                <c:ptCount val="12"/>
                <c:pt idx="0">
                  <c:v>0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9</c:v>
                </c:pt>
                <c:pt idx="9">
                  <c:v>22</c:v>
                </c:pt>
                <c:pt idx="10">
                  <c:v>43</c:v>
                </c:pt>
                <c:pt idx="11">
                  <c:v>58</c:v>
                </c:pt>
              </c:numCache>
            </c:numRef>
          </c:xVal>
          <c:yVal>
            <c:numRef>
              <c:f>Sheet1!$B$2:$B$13</c:f>
              <c:numCache>
                <c:formatCode>General</c:formatCode>
                <c:ptCount val="12"/>
                <c:pt idx="0">
                  <c:v>2.1298743267504524E-2</c:v>
                </c:pt>
                <c:pt idx="1">
                  <c:v>3.3337163375224473E-2</c:v>
                </c:pt>
                <c:pt idx="2">
                  <c:v>0.12686642728904846</c:v>
                </c:pt>
                <c:pt idx="3">
                  <c:v>0.3593005385996409</c:v>
                </c:pt>
                <c:pt idx="4">
                  <c:v>1.4566488330341114</c:v>
                </c:pt>
                <c:pt idx="5">
                  <c:v>2.1057974865350091</c:v>
                </c:pt>
                <c:pt idx="6">
                  <c:v>3.2911188509874325</c:v>
                </c:pt>
                <c:pt idx="7">
                  <c:v>4.2115949730700182</c:v>
                </c:pt>
                <c:pt idx="8">
                  <c:v>4.4847745062836619</c:v>
                </c:pt>
                <c:pt idx="9">
                  <c:v>4.7885131059245962</c:v>
                </c:pt>
                <c:pt idx="10">
                  <c:v>5.5941612208258533</c:v>
                </c:pt>
                <c:pt idx="11">
                  <c:v>6.160892998204668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A20-4D53-B018-71292928D94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22331520"/>
        <c:axId val="1315625040"/>
      </c:scatterChart>
      <c:valAx>
        <c:axId val="622331520"/>
        <c:scaling>
          <c:orientation val="minMax"/>
          <c:max val="8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Cultivation time (h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15625040"/>
        <c:crosses val="autoZero"/>
        <c:crossBetween val="midCat"/>
        <c:majorUnit val="12"/>
      </c:valAx>
      <c:valAx>
        <c:axId val="1315625040"/>
        <c:scaling>
          <c:orientation val="minMax"/>
          <c:max val="8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OD</a:t>
                </a:r>
                <a:r>
                  <a:rPr lang="en-US" baseline="-25000" dirty="0"/>
                  <a:t>600</a:t>
                </a:r>
                <a:endParaRPr lang="ja-JP" baseline="-2500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22331520"/>
        <c:crosses val="autoZero"/>
        <c:crossBetween val="midCat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519252065603803"/>
          <c:y val="8.5513710429674691E-2"/>
          <c:w val="0.66525018112745737"/>
          <c:h val="0.54301526509071663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OD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bg1">
                  <a:lumMod val="50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C$2:$C$13</c:f>
                <c:numCache>
                  <c:formatCode>General</c:formatCode>
                  <c:ptCount val="12"/>
                  <c:pt idx="0">
                    <c:v>1.8192182839694322E-2</c:v>
                  </c:pt>
                  <c:pt idx="1">
                    <c:v>1.4262937022606594E-2</c:v>
                  </c:pt>
                  <c:pt idx="2">
                    <c:v>3.0231159946780502E-2</c:v>
                  </c:pt>
                  <c:pt idx="3">
                    <c:v>6.4542921399324882E-2</c:v>
                  </c:pt>
                  <c:pt idx="4">
                    <c:v>0.11845122255580326</c:v>
                  </c:pt>
                  <c:pt idx="5">
                    <c:v>6.5034996538328893E-2</c:v>
                  </c:pt>
                  <c:pt idx="6">
                    <c:v>0.1499659750558287</c:v>
                  </c:pt>
                  <c:pt idx="7">
                    <c:v>0.34243021241280636</c:v>
                  </c:pt>
                  <c:pt idx="8">
                    <c:v>9.7626387911210893E-2</c:v>
                  </c:pt>
                  <c:pt idx="9">
                    <c:v>0.1629861764167323</c:v>
                  </c:pt>
                  <c:pt idx="10">
                    <c:v>9.7766242736784692E-2</c:v>
                  </c:pt>
                </c:numCache>
              </c:numRef>
            </c:plus>
            <c:minus>
              <c:numRef>
                <c:f>Sheet1!$C$2:$C$13</c:f>
                <c:numCache>
                  <c:formatCode>General</c:formatCode>
                  <c:ptCount val="12"/>
                  <c:pt idx="0">
                    <c:v>1.8192182839694322E-2</c:v>
                  </c:pt>
                  <c:pt idx="1">
                    <c:v>1.4262937022606594E-2</c:v>
                  </c:pt>
                  <c:pt idx="2">
                    <c:v>3.0231159946780502E-2</c:v>
                  </c:pt>
                  <c:pt idx="3">
                    <c:v>6.4542921399324882E-2</c:v>
                  </c:pt>
                  <c:pt idx="4">
                    <c:v>0.11845122255580326</c:v>
                  </c:pt>
                  <c:pt idx="5">
                    <c:v>6.5034996538328893E-2</c:v>
                  </c:pt>
                  <c:pt idx="6">
                    <c:v>0.1499659750558287</c:v>
                  </c:pt>
                  <c:pt idx="7">
                    <c:v>0.34243021241280636</c:v>
                  </c:pt>
                  <c:pt idx="8">
                    <c:v>9.7626387911210893E-2</c:v>
                  </c:pt>
                  <c:pt idx="9">
                    <c:v>0.1629861764167323</c:v>
                  </c:pt>
                  <c:pt idx="10">
                    <c:v>9.7766242736784692E-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Sheet1!$A$2:$A$13</c:f>
              <c:numCache>
                <c:formatCode>General</c:formatCode>
                <c:ptCount val="12"/>
                <c:pt idx="0">
                  <c:v>0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9</c:v>
                </c:pt>
                <c:pt idx="9">
                  <c:v>43</c:v>
                </c:pt>
                <c:pt idx="10">
                  <c:v>58</c:v>
                </c:pt>
              </c:numCache>
            </c:numRef>
          </c:xVal>
          <c:yVal>
            <c:numRef>
              <c:f>Sheet1!$B$2:$B$13</c:f>
              <c:numCache>
                <c:formatCode>General</c:formatCode>
                <c:ptCount val="12"/>
                <c:pt idx="0">
                  <c:v>-4.0241200392651571E-3</c:v>
                </c:pt>
                <c:pt idx="1">
                  <c:v>-7.0422100687140589E-3</c:v>
                </c:pt>
                <c:pt idx="2">
                  <c:v>0.23641705230682938</c:v>
                </c:pt>
                <c:pt idx="3">
                  <c:v>1.2836942925255925</c:v>
                </c:pt>
                <c:pt idx="4">
                  <c:v>5.3983570326742401</c:v>
                </c:pt>
                <c:pt idx="5">
                  <c:v>5.7756182863553507</c:v>
                </c:pt>
                <c:pt idx="6">
                  <c:v>5.6589188052166604</c:v>
                </c:pt>
                <c:pt idx="7">
                  <c:v>5.7554976861590204</c:v>
                </c:pt>
                <c:pt idx="8">
                  <c:v>5.6066052447062136</c:v>
                </c:pt>
                <c:pt idx="9">
                  <c:v>5.1146565699060451</c:v>
                </c:pt>
                <c:pt idx="10">
                  <c:v>5.298760061702426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25D-4924-85EC-E552AE7374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15610352"/>
        <c:axId val="1315610896"/>
      </c:scatterChart>
      <c:valAx>
        <c:axId val="1315610352"/>
        <c:scaling>
          <c:orientation val="minMax"/>
          <c:max val="8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Cultivation time (h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15610896"/>
        <c:crosses val="autoZero"/>
        <c:crossBetween val="midCat"/>
        <c:majorUnit val="12"/>
      </c:valAx>
      <c:valAx>
        <c:axId val="1315610896"/>
        <c:scaling>
          <c:orientation val="minMax"/>
          <c:max val="8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OD</a:t>
                </a:r>
                <a:r>
                  <a:rPr lang="en-US" baseline="-25000" dirty="0"/>
                  <a:t>600</a:t>
                </a:r>
                <a:endParaRPr lang="ja-JP" baseline="-2500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15610352"/>
        <c:crosses val="autoZero"/>
        <c:crossBetween val="midCat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OD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bg1">
                  <a:lumMod val="50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C$2:$C$16</c:f>
                <c:numCache>
                  <c:formatCode>General</c:formatCode>
                  <c:ptCount val="15"/>
                  <c:pt idx="0">
                    <c:v>7.9761311928908934E-3</c:v>
                  </c:pt>
                  <c:pt idx="1">
                    <c:v>9.4133796941261866E-3</c:v>
                  </c:pt>
                  <c:pt idx="2">
                    <c:v>2.4258455978429537E-2</c:v>
                  </c:pt>
                  <c:pt idx="3">
                    <c:v>2.0722596710882852E-2</c:v>
                  </c:pt>
                  <c:pt idx="4">
                    <c:v>8.2657066308475122E-2</c:v>
                  </c:pt>
                  <c:pt idx="5">
                    <c:v>5.8073632672959084E-2</c:v>
                  </c:pt>
                  <c:pt idx="6">
                    <c:v>6.611740606763214E-2</c:v>
                  </c:pt>
                  <c:pt idx="7">
                    <c:v>6.0293884459470337E-3</c:v>
                  </c:pt>
                  <c:pt idx="8">
                    <c:v>7.8207931737476463E-2</c:v>
                  </c:pt>
                  <c:pt idx="9">
                    <c:v>6.6682010546255374E-2</c:v>
                  </c:pt>
                  <c:pt idx="10">
                    <c:v>4.4485896854350622E-2</c:v>
                  </c:pt>
                  <c:pt idx="11">
                    <c:v>5.9706930489366733E-2</c:v>
                  </c:pt>
                  <c:pt idx="12">
                    <c:v>1.7383574915116641E-2</c:v>
                  </c:pt>
                  <c:pt idx="13">
                    <c:v>0.17220080124562628</c:v>
                  </c:pt>
                  <c:pt idx="14">
                    <c:v>1.4379174997897624E-2</c:v>
                  </c:pt>
                </c:numCache>
              </c:numRef>
            </c:plus>
            <c:minus>
              <c:numRef>
                <c:f>Sheet1!$C$2:$C$16</c:f>
                <c:numCache>
                  <c:formatCode>General</c:formatCode>
                  <c:ptCount val="15"/>
                  <c:pt idx="0">
                    <c:v>7.9761311928908934E-3</c:v>
                  </c:pt>
                  <c:pt idx="1">
                    <c:v>9.4133796941261866E-3</c:v>
                  </c:pt>
                  <c:pt idx="2">
                    <c:v>2.4258455978429537E-2</c:v>
                  </c:pt>
                  <c:pt idx="3">
                    <c:v>2.0722596710882852E-2</c:v>
                  </c:pt>
                  <c:pt idx="4">
                    <c:v>8.2657066308475122E-2</c:v>
                  </c:pt>
                  <c:pt idx="5">
                    <c:v>5.8073632672959084E-2</c:v>
                  </c:pt>
                  <c:pt idx="6">
                    <c:v>6.611740606763214E-2</c:v>
                  </c:pt>
                  <c:pt idx="7">
                    <c:v>6.0293884459470337E-3</c:v>
                  </c:pt>
                  <c:pt idx="8">
                    <c:v>7.8207931737476463E-2</c:v>
                  </c:pt>
                  <c:pt idx="9">
                    <c:v>6.6682010546255374E-2</c:v>
                  </c:pt>
                  <c:pt idx="10">
                    <c:v>4.4485896854350622E-2</c:v>
                  </c:pt>
                  <c:pt idx="11">
                    <c:v>5.9706930489366733E-2</c:v>
                  </c:pt>
                  <c:pt idx="12">
                    <c:v>1.7383574915116641E-2</c:v>
                  </c:pt>
                  <c:pt idx="13">
                    <c:v>0.17220080124562628</c:v>
                  </c:pt>
                  <c:pt idx="14">
                    <c:v>1.4379174997897624E-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Sheet1!$A$2:$A$16</c:f>
              <c:numCache>
                <c:formatCode>General</c:formatCode>
                <c:ptCount val="15"/>
                <c:pt idx="0">
                  <c:v>0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9</c:v>
                </c:pt>
                <c:pt idx="5">
                  <c:v>9.5</c:v>
                </c:pt>
                <c:pt idx="6">
                  <c:v>10</c:v>
                </c:pt>
                <c:pt idx="7">
                  <c:v>11</c:v>
                </c:pt>
                <c:pt idx="8">
                  <c:v>12</c:v>
                </c:pt>
                <c:pt idx="9">
                  <c:v>13</c:v>
                </c:pt>
                <c:pt idx="10">
                  <c:v>13.5</c:v>
                </c:pt>
                <c:pt idx="11">
                  <c:v>14</c:v>
                </c:pt>
                <c:pt idx="12">
                  <c:v>25</c:v>
                </c:pt>
                <c:pt idx="13">
                  <c:v>26</c:v>
                </c:pt>
                <c:pt idx="14">
                  <c:v>51</c:v>
                </c:pt>
              </c:numCache>
            </c:numRef>
          </c:xVal>
          <c:yVal>
            <c:numRef>
              <c:f>Sheet1!$B$2:$B$16</c:f>
              <c:numCache>
                <c:formatCode>General</c:formatCode>
                <c:ptCount val="15"/>
                <c:pt idx="0">
                  <c:v>2.6108017817372078E-3</c:v>
                </c:pt>
                <c:pt idx="1">
                  <c:v>7.8324053452115041E-3</c:v>
                </c:pt>
                <c:pt idx="2">
                  <c:v>1.13134743875278E-2</c:v>
                </c:pt>
                <c:pt idx="3">
                  <c:v>0.1827561247216036</c:v>
                </c:pt>
                <c:pt idx="4">
                  <c:v>0.50214420935412019</c:v>
                </c:pt>
                <c:pt idx="5">
                  <c:v>1.1792121380846323</c:v>
                </c:pt>
                <c:pt idx="6">
                  <c:v>1.8084153674832957</c:v>
                </c:pt>
                <c:pt idx="7">
                  <c:v>1.9807282850779508</c:v>
                </c:pt>
                <c:pt idx="8">
                  <c:v>2.3401486636971045</c:v>
                </c:pt>
                <c:pt idx="9">
                  <c:v>2.7483040089086859</c:v>
                </c:pt>
                <c:pt idx="10">
                  <c:v>2.8353307349665919</c:v>
                </c:pt>
                <c:pt idx="11">
                  <c:v>2.8692711581291754</c:v>
                </c:pt>
                <c:pt idx="12">
                  <c:v>2.6195044543429842</c:v>
                </c:pt>
                <c:pt idx="13">
                  <c:v>2.4915751670378619</c:v>
                </c:pt>
                <c:pt idx="14">
                  <c:v>2.201776169265033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067-46B3-A398-AEBBF87EB5D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15621232"/>
        <c:axId val="1315618512"/>
      </c:scatterChart>
      <c:valAx>
        <c:axId val="1315621232"/>
        <c:scaling>
          <c:orientation val="minMax"/>
          <c:max val="8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Cultivation time (h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15618512"/>
        <c:crosses val="autoZero"/>
        <c:crossBetween val="midCat"/>
        <c:majorUnit val="12"/>
      </c:valAx>
      <c:valAx>
        <c:axId val="1315618512"/>
        <c:scaling>
          <c:orientation val="minMax"/>
          <c:max val="8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OD</a:t>
                </a:r>
                <a:r>
                  <a:rPr lang="en-US" baseline="-25000" dirty="0"/>
                  <a:t>600</a:t>
                </a:r>
                <a:endParaRPr lang="ja-JP" baseline="-2500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15621232"/>
        <c:crosses val="autoZero"/>
        <c:crossBetween val="midCat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OD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bg1">
                  <a:lumMod val="50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C$2:$C$13</c:f>
                <c:numCache>
                  <c:formatCode>General</c:formatCode>
                  <c:ptCount val="12"/>
                  <c:pt idx="0">
                    <c:v>6.5896836327615491E-2</c:v>
                  </c:pt>
                  <c:pt idx="1">
                    <c:v>1.5117771065848308E-2</c:v>
                  </c:pt>
                  <c:pt idx="2">
                    <c:v>1.9022778096246702E-2</c:v>
                  </c:pt>
                  <c:pt idx="3">
                    <c:v>5.2792080076712065E-2</c:v>
                  </c:pt>
                  <c:pt idx="4">
                    <c:v>0.12867385355731586</c:v>
                  </c:pt>
                  <c:pt idx="5">
                    <c:v>0.19570556562959279</c:v>
                  </c:pt>
                  <c:pt idx="6">
                    <c:v>0.38782640630433662</c:v>
                  </c:pt>
                  <c:pt idx="7">
                    <c:v>0.20545403759411057</c:v>
                  </c:pt>
                  <c:pt idx="8">
                    <c:v>1.3811701696265803</c:v>
                  </c:pt>
                  <c:pt idx="9">
                    <c:v>0.42068742601766351</c:v>
                  </c:pt>
                  <c:pt idx="10">
                    <c:v>1.5456786321640656</c:v>
                  </c:pt>
                  <c:pt idx="11">
                    <c:v>0.41388685232365291</c:v>
                  </c:pt>
                </c:numCache>
              </c:numRef>
            </c:plus>
            <c:minus>
              <c:numRef>
                <c:f>Sheet1!$C$2:$C$13</c:f>
                <c:numCache>
                  <c:formatCode>General</c:formatCode>
                  <c:ptCount val="12"/>
                  <c:pt idx="0">
                    <c:v>6.5896836327615491E-2</c:v>
                  </c:pt>
                  <c:pt idx="1">
                    <c:v>1.5117771065848308E-2</c:v>
                  </c:pt>
                  <c:pt idx="2">
                    <c:v>1.9022778096246702E-2</c:v>
                  </c:pt>
                  <c:pt idx="3">
                    <c:v>5.2792080076712065E-2</c:v>
                  </c:pt>
                  <c:pt idx="4">
                    <c:v>0.12867385355731586</c:v>
                  </c:pt>
                  <c:pt idx="5">
                    <c:v>0.19570556562959279</c:v>
                  </c:pt>
                  <c:pt idx="6">
                    <c:v>0.38782640630433662</c:v>
                  </c:pt>
                  <c:pt idx="7">
                    <c:v>0.20545403759411057</c:v>
                  </c:pt>
                  <c:pt idx="8">
                    <c:v>1.3811701696265803</c:v>
                  </c:pt>
                  <c:pt idx="9">
                    <c:v>0.42068742601766351</c:v>
                  </c:pt>
                  <c:pt idx="10">
                    <c:v>1.5456786321640656</c:v>
                  </c:pt>
                  <c:pt idx="11">
                    <c:v>0.41388685232365291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Sheet1!$A$2:$A$13</c:f>
              <c:numCache>
                <c:formatCode>General</c:formatCode>
                <c:ptCount val="12"/>
                <c:pt idx="0">
                  <c:v>0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9</c:v>
                </c:pt>
                <c:pt idx="9">
                  <c:v>22</c:v>
                </c:pt>
                <c:pt idx="10">
                  <c:v>43</c:v>
                </c:pt>
                <c:pt idx="11">
                  <c:v>58</c:v>
                </c:pt>
              </c:numCache>
            </c:numRef>
          </c:xVal>
          <c:yVal>
            <c:numRef>
              <c:f>Sheet1!$B$2:$B$13</c:f>
              <c:numCache>
                <c:formatCode>General</c:formatCode>
                <c:ptCount val="12"/>
                <c:pt idx="0">
                  <c:v>8.7282491944145543E-3</c:v>
                </c:pt>
                <c:pt idx="1">
                  <c:v>-8.7282491944146567E-3</c:v>
                </c:pt>
                <c:pt idx="2">
                  <c:v>-2.6184747583243764E-2</c:v>
                </c:pt>
                <c:pt idx="3">
                  <c:v>9.4556032939491552E-2</c:v>
                </c:pt>
                <c:pt idx="4">
                  <c:v>0.41313712853562484</c:v>
                </c:pt>
                <c:pt idx="5">
                  <c:v>0.60224919441460789</c:v>
                </c:pt>
                <c:pt idx="6">
                  <c:v>2.3333519513068381</c:v>
                </c:pt>
                <c:pt idx="7">
                  <c:v>5.3780562119584667</c:v>
                </c:pt>
                <c:pt idx="8">
                  <c:v>7.1717114214106674</c:v>
                </c:pt>
                <c:pt idx="9">
                  <c:v>8.664242033655567</c:v>
                </c:pt>
                <c:pt idx="10">
                  <c:v>11.851507697815967</c:v>
                </c:pt>
                <c:pt idx="11">
                  <c:v>11.28708091657715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7C1-42E5-8031-52130041062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15613616"/>
        <c:axId val="1315637552"/>
      </c:scatterChart>
      <c:valAx>
        <c:axId val="1315613616"/>
        <c:scaling>
          <c:orientation val="minMax"/>
          <c:max val="8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Cultivation time (h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15637552"/>
        <c:crosses val="autoZero"/>
        <c:crossBetween val="midCat"/>
        <c:majorUnit val="12"/>
      </c:valAx>
      <c:valAx>
        <c:axId val="1315637552"/>
        <c:scaling>
          <c:orientation val="minMax"/>
          <c:max val="14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OD</a:t>
                </a:r>
                <a:r>
                  <a:rPr lang="en-US" baseline="-25000" dirty="0"/>
                  <a:t>600</a:t>
                </a:r>
                <a:endParaRPr lang="ja-JP" baseline="-2500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15613616"/>
        <c:crosses val="autoZero"/>
        <c:crossBetween val="midCat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OD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bg1">
                  <a:lumMod val="50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C$2:$C$13</c:f>
                <c:numCache>
                  <c:formatCode>General</c:formatCode>
                  <c:ptCount val="12"/>
                  <c:pt idx="0">
                    <c:v>1.4826998488456254E-2</c:v>
                  </c:pt>
                  <c:pt idx="1">
                    <c:v>2.5681114705753162E-2</c:v>
                  </c:pt>
                  <c:pt idx="2">
                    <c:v>4.5119591726669683E-2</c:v>
                  </c:pt>
                  <c:pt idx="3">
                    <c:v>7.952459400498749E-3</c:v>
                  </c:pt>
                  <c:pt idx="4">
                    <c:v>0.18487177509376054</c:v>
                  </c:pt>
                  <c:pt idx="5">
                    <c:v>0.26164391380570517</c:v>
                  </c:pt>
                  <c:pt idx="6">
                    <c:v>0.23302457250608094</c:v>
                  </c:pt>
                  <c:pt idx="7">
                    <c:v>0.41040282386605276</c:v>
                  </c:pt>
                  <c:pt idx="8">
                    <c:v>0.33340768175999352</c:v>
                  </c:pt>
                  <c:pt idx="9">
                    <c:v>0.36964579908199546</c:v>
                  </c:pt>
                  <c:pt idx="10">
                    <c:v>0.10759287257898177</c:v>
                  </c:pt>
                  <c:pt idx="11">
                    <c:v>0.15803294955016148</c:v>
                  </c:pt>
                </c:numCache>
              </c:numRef>
            </c:plus>
            <c:minus>
              <c:numRef>
                <c:f>Sheet1!$C$2:$C$13</c:f>
                <c:numCache>
                  <c:formatCode>General</c:formatCode>
                  <c:ptCount val="12"/>
                  <c:pt idx="0">
                    <c:v>1.4826998488456254E-2</c:v>
                  </c:pt>
                  <c:pt idx="1">
                    <c:v>2.5681114705753162E-2</c:v>
                  </c:pt>
                  <c:pt idx="2">
                    <c:v>4.5119591726669683E-2</c:v>
                  </c:pt>
                  <c:pt idx="3">
                    <c:v>7.952459400498749E-3</c:v>
                  </c:pt>
                  <c:pt idx="4">
                    <c:v>0.18487177509376054</c:v>
                  </c:pt>
                  <c:pt idx="5">
                    <c:v>0.26164391380570517</c:v>
                  </c:pt>
                  <c:pt idx="6">
                    <c:v>0.23302457250608094</c:v>
                  </c:pt>
                  <c:pt idx="7">
                    <c:v>0.41040282386605276</c:v>
                  </c:pt>
                  <c:pt idx="8">
                    <c:v>0.33340768175999352</c:v>
                  </c:pt>
                  <c:pt idx="9">
                    <c:v>0.36964579908199546</c:v>
                  </c:pt>
                  <c:pt idx="10">
                    <c:v>0.10759287257898177</c:v>
                  </c:pt>
                  <c:pt idx="11">
                    <c:v>0.1580329495501614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Sheet1!$A$2:$A$13</c:f>
              <c:numCache>
                <c:formatCode>General</c:formatCode>
                <c:ptCount val="1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.25</c:v>
                </c:pt>
                <c:pt idx="5">
                  <c:v>10</c:v>
                </c:pt>
                <c:pt idx="6">
                  <c:v>12</c:v>
                </c:pt>
                <c:pt idx="7">
                  <c:v>16</c:v>
                </c:pt>
                <c:pt idx="8">
                  <c:v>19.5</c:v>
                </c:pt>
                <c:pt idx="9">
                  <c:v>34</c:v>
                </c:pt>
                <c:pt idx="10">
                  <c:v>59</c:v>
                </c:pt>
                <c:pt idx="11">
                  <c:v>82</c:v>
                </c:pt>
              </c:numCache>
            </c:numRef>
          </c:xVal>
          <c:yVal>
            <c:numRef>
              <c:f>Sheet1!$B$2:$B$13</c:f>
              <c:numCache>
                <c:formatCode>General</c:formatCode>
                <c:ptCount val="12"/>
                <c:pt idx="0">
                  <c:v>-1.4026819923371701E-2</c:v>
                </c:pt>
                <c:pt idx="1">
                  <c:v>-2.4045977011494246E-2</c:v>
                </c:pt>
                <c:pt idx="2">
                  <c:v>-3.2061302681992282E-2</c:v>
                </c:pt>
                <c:pt idx="3">
                  <c:v>0.81756321839080448</c:v>
                </c:pt>
                <c:pt idx="4">
                  <c:v>3.5918678160919537</c:v>
                </c:pt>
                <c:pt idx="5">
                  <c:v>7.0554904214559384</c:v>
                </c:pt>
                <c:pt idx="6">
                  <c:v>8.0924731800766256</c:v>
                </c:pt>
                <c:pt idx="7">
                  <c:v>9.0082241379310339</c:v>
                </c:pt>
                <c:pt idx="8">
                  <c:v>8.3800229885057469</c:v>
                </c:pt>
                <c:pt idx="9">
                  <c:v>9.5552701149425285</c:v>
                </c:pt>
                <c:pt idx="10">
                  <c:v>10.175455938697317</c:v>
                </c:pt>
                <c:pt idx="11">
                  <c:v>10.79463984674329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0EA-4BD0-94A0-F6446034A2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15632112"/>
        <c:axId val="1315632656"/>
      </c:scatterChart>
      <c:valAx>
        <c:axId val="1315632112"/>
        <c:scaling>
          <c:orientation val="minMax"/>
          <c:max val="8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Cultivation time (h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15632656"/>
        <c:crosses val="autoZero"/>
        <c:crossBetween val="midCat"/>
        <c:majorUnit val="12"/>
      </c:valAx>
      <c:valAx>
        <c:axId val="1315632656"/>
        <c:scaling>
          <c:orientation val="minMax"/>
          <c:max val="14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OD</a:t>
                </a:r>
                <a:r>
                  <a:rPr lang="en-US" baseline="-25000" dirty="0"/>
                  <a:t>600</a:t>
                </a:r>
                <a:endParaRPr lang="ja-JP" baseline="-2500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15632112"/>
        <c:crosses val="autoZero"/>
        <c:crossBetween val="midCat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OD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bg1">
                  <a:lumMod val="65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C$2:$C$13</c:f>
                <c:numCache>
                  <c:formatCode>General</c:formatCode>
                  <c:ptCount val="12"/>
                  <c:pt idx="0">
                    <c:v>5.7829177244370623E-2</c:v>
                  </c:pt>
                  <c:pt idx="1">
                    <c:v>5.6012925628235288E-2</c:v>
                  </c:pt>
                  <c:pt idx="2">
                    <c:v>2.6195859796173449E-2</c:v>
                  </c:pt>
                  <c:pt idx="3">
                    <c:v>3.9588200452531731E-2</c:v>
                  </c:pt>
                  <c:pt idx="4">
                    <c:v>0.29513620726556139</c:v>
                  </c:pt>
                  <c:pt idx="5">
                    <c:v>6.1544387399338867E-2</c:v>
                  </c:pt>
                  <c:pt idx="6">
                    <c:v>0.23696713715892176</c:v>
                  </c:pt>
                  <c:pt idx="7">
                    <c:v>0.13825830149463095</c:v>
                  </c:pt>
                  <c:pt idx="8">
                    <c:v>0.24301674131991713</c:v>
                  </c:pt>
                  <c:pt idx="9">
                    <c:v>0.42997521282852602</c:v>
                  </c:pt>
                  <c:pt idx="10">
                    <c:v>0.14166255345665443</c:v>
                  </c:pt>
                  <c:pt idx="11">
                    <c:v>0.10373435686824085</c:v>
                  </c:pt>
                </c:numCache>
              </c:numRef>
            </c:plus>
            <c:minus>
              <c:numRef>
                <c:f>Sheet1!$C$2:$C$13</c:f>
                <c:numCache>
                  <c:formatCode>General</c:formatCode>
                  <c:ptCount val="12"/>
                  <c:pt idx="0">
                    <c:v>5.7829177244370623E-2</c:v>
                  </c:pt>
                  <c:pt idx="1">
                    <c:v>5.6012925628235288E-2</c:v>
                  </c:pt>
                  <c:pt idx="2">
                    <c:v>2.6195859796173449E-2</c:v>
                  </c:pt>
                  <c:pt idx="3">
                    <c:v>3.9588200452531731E-2</c:v>
                  </c:pt>
                  <c:pt idx="4">
                    <c:v>0.29513620726556139</c:v>
                  </c:pt>
                  <c:pt idx="5">
                    <c:v>6.1544387399338867E-2</c:v>
                  </c:pt>
                  <c:pt idx="6">
                    <c:v>0.23696713715892176</c:v>
                  </c:pt>
                  <c:pt idx="7">
                    <c:v>0.13825830149463095</c:v>
                  </c:pt>
                  <c:pt idx="8">
                    <c:v>0.24301674131991713</c:v>
                  </c:pt>
                  <c:pt idx="9">
                    <c:v>0.42997521282852602</c:v>
                  </c:pt>
                  <c:pt idx="10">
                    <c:v>0.14166255345665443</c:v>
                  </c:pt>
                  <c:pt idx="11">
                    <c:v>0.1037343568682408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Sheet1!$A$2:$A$13</c:f>
              <c:numCache>
                <c:formatCode>General</c:formatCode>
                <c:ptCount val="1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.25</c:v>
                </c:pt>
                <c:pt idx="5">
                  <c:v>10</c:v>
                </c:pt>
                <c:pt idx="6">
                  <c:v>12</c:v>
                </c:pt>
                <c:pt idx="7">
                  <c:v>16</c:v>
                </c:pt>
                <c:pt idx="8">
                  <c:v>19.5</c:v>
                </c:pt>
                <c:pt idx="9">
                  <c:v>34</c:v>
                </c:pt>
                <c:pt idx="10">
                  <c:v>59</c:v>
                </c:pt>
                <c:pt idx="11">
                  <c:v>82</c:v>
                </c:pt>
              </c:numCache>
            </c:numRef>
          </c:xVal>
          <c:yVal>
            <c:numRef>
              <c:f>Sheet1!$B$2:$B$13</c:f>
              <c:numCache>
                <c:formatCode>General</c:formatCode>
                <c:ptCount val="12"/>
                <c:pt idx="0">
                  <c:v>-2.9983031674208238E-2</c:v>
                </c:pt>
                <c:pt idx="1">
                  <c:v>-2.6984728506787344E-2</c:v>
                </c:pt>
                <c:pt idx="2">
                  <c:v>3.9977375565610623E-3</c:v>
                </c:pt>
                <c:pt idx="3">
                  <c:v>1.4281917420814478</c:v>
                </c:pt>
                <c:pt idx="4">
                  <c:v>3.2901380090497736</c:v>
                </c:pt>
                <c:pt idx="5">
                  <c:v>4.9631911764705885</c:v>
                </c:pt>
                <c:pt idx="6">
                  <c:v>5.623817307692307</c:v>
                </c:pt>
                <c:pt idx="7">
                  <c:v>5.6977754524886883</c:v>
                </c:pt>
                <c:pt idx="8">
                  <c:v>5.8836702488687784</c:v>
                </c:pt>
                <c:pt idx="9">
                  <c:v>5.8656804298642529</c:v>
                </c:pt>
                <c:pt idx="10">
                  <c:v>5.649802601809955</c:v>
                </c:pt>
                <c:pt idx="11">
                  <c:v>6.56328563348416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82D-4829-B04F-947AEB8224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15616880"/>
        <c:axId val="1315619600"/>
      </c:scatterChart>
      <c:valAx>
        <c:axId val="1315616880"/>
        <c:scaling>
          <c:orientation val="minMax"/>
          <c:max val="8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Cultivation time (h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15619600"/>
        <c:crosses val="autoZero"/>
        <c:crossBetween val="midCat"/>
        <c:majorUnit val="12"/>
      </c:valAx>
      <c:valAx>
        <c:axId val="1315619600"/>
        <c:scaling>
          <c:orientation val="minMax"/>
          <c:max val="8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OD</a:t>
                </a:r>
                <a:r>
                  <a:rPr lang="en-US" baseline="-25000" dirty="0"/>
                  <a:t>600</a:t>
                </a:r>
                <a:endParaRPr lang="ja-JP" baseline="-2500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15616880"/>
        <c:crosses val="autoZero"/>
        <c:crossBetween val="midCat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OD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bg1">
                  <a:lumMod val="50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C$2:$C$13</c:f>
                <c:numCache>
                  <c:formatCode>General</c:formatCode>
                  <c:ptCount val="12"/>
                  <c:pt idx="0">
                    <c:v>3.4881949191648276E-2</c:v>
                  </c:pt>
                  <c:pt idx="1">
                    <c:v>1.4426654302801694E-2</c:v>
                  </c:pt>
                  <c:pt idx="2">
                    <c:v>5.9212855677688241E-2</c:v>
                  </c:pt>
                  <c:pt idx="3">
                    <c:v>2.0006169931593956E-3</c:v>
                  </c:pt>
                  <c:pt idx="4">
                    <c:v>1.7781872789786032E-2</c:v>
                  </c:pt>
                  <c:pt idx="5">
                    <c:v>0.12208682217076883</c:v>
                  </c:pt>
                  <c:pt idx="6">
                    <c:v>0.21546375665094455</c:v>
                  </c:pt>
                  <c:pt idx="7">
                    <c:v>0.35518136216338275</c:v>
                  </c:pt>
                  <c:pt idx="8">
                    <c:v>4.9774771829752637E-2</c:v>
                  </c:pt>
                  <c:pt idx="9">
                    <c:v>0.16459862783027934</c:v>
                  </c:pt>
                  <c:pt idx="10">
                    <c:v>8.7456943824895786E-2</c:v>
                  </c:pt>
                  <c:pt idx="11">
                    <c:v>5.1435703373661511E-2</c:v>
                  </c:pt>
                </c:numCache>
              </c:numRef>
            </c:plus>
            <c:minus>
              <c:numRef>
                <c:f>Sheet1!$C$2:$C$13</c:f>
                <c:numCache>
                  <c:formatCode>General</c:formatCode>
                  <c:ptCount val="12"/>
                  <c:pt idx="0">
                    <c:v>3.4881949191648276E-2</c:v>
                  </c:pt>
                  <c:pt idx="1">
                    <c:v>1.4426654302801694E-2</c:v>
                  </c:pt>
                  <c:pt idx="2">
                    <c:v>5.9212855677688241E-2</c:v>
                  </c:pt>
                  <c:pt idx="3">
                    <c:v>2.0006169931593956E-3</c:v>
                  </c:pt>
                  <c:pt idx="4">
                    <c:v>1.7781872789786032E-2</c:v>
                  </c:pt>
                  <c:pt idx="5">
                    <c:v>0.12208682217076883</c:v>
                  </c:pt>
                  <c:pt idx="6">
                    <c:v>0.21546375665094455</c:v>
                  </c:pt>
                  <c:pt idx="7">
                    <c:v>0.35518136216338275</c:v>
                  </c:pt>
                  <c:pt idx="8">
                    <c:v>4.9774771829752637E-2</c:v>
                  </c:pt>
                  <c:pt idx="9">
                    <c:v>0.16459862783027934</c:v>
                  </c:pt>
                  <c:pt idx="10">
                    <c:v>8.7456943824895786E-2</c:v>
                  </c:pt>
                  <c:pt idx="11">
                    <c:v>5.1435703373661511E-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Sheet1!$A$2:$A$13</c:f>
              <c:numCache>
                <c:formatCode>General</c:formatCode>
                <c:ptCount val="1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.25</c:v>
                </c:pt>
                <c:pt idx="5">
                  <c:v>10</c:v>
                </c:pt>
                <c:pt idx="6">
                  <c:v>12</c:v>
                </c:pt>
                <c:pt idx="7">
                  <c:v>16</c:v>
                </c:pt>
                <c:pt idx="8">
                  <c:v>19.5</c:v>
                </c:pt>
                <c:pt idx="9">
                  <c:v>34</c:v>
                </c:pt>
                <c:pt idx="10">
                  <c:v>59</c:v>
                </c:pt>
                <c:pt idx="11">
                  <c:v>82</c:v>
                </c:pt>
              </c:numCache>
            </c:numRef>
          </c:xVal>
          <c:yVal>
            <c:numRef>
              <c:f>Sheet1!$B$2:$B$13</c:f>
              <c:numCache>
                <c:formatCode>General</c:formatCode>
                <c:ptCount val="12"/>
                <c:pt idx="0">
                  <c:v>-6.4683178534571825E-2</c:v>
                </c:pt>
                <c:pt idx="1">
                  <c:v>-4.2737100103199199E-2</c:v>
                </c:pt>
                <c:pt idx="2">
                  <c:v>-0.10742027863777093</c:v>
                </c:pt>
                <c:pt idx="3">
                  <c:v>-3.0031475748194075E-2</c:v>
                </c:pt>
                <c:pt idx="4">
                  <c:v>2.3101135190918411E-2</c:v>
                </c:pt>
                <c:pt idx="5">
                  <c:v>0.36846310629514956</c:v>
                </c:pt>
                <c:pt idx="6">
                  <c:v>1.1758477812177504</c:v>
                </c:pt>
                <c:pt idx="7">
                  <c:v>2.7351744066047474</c:v>
                </c:pt>
                <c:pt idx="8">
                  <c:v>3.5506444788441698</c:v>
                </c:pt>
                <c:pt idx="9">
                  <c:v>4.233283023735809</c:v>
                </c:pt>
                <c:pt idx="10">
                  <c:v>3.9710851393188853</c:v>
                </c:pt>
                <c:pt idx="11">
                  <c:v>4.10045149638802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2DF-4BC9-84BC-761E24F4716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15623408"/>
        <c:axId val="1315620688"/>
      </c:scatterChart>
      <c:valAx>
        <c:axId val="1315623408"/>
        <c:scaling>
          <c:orientation val="minMax"/>
          <c:max val="8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Cultivation time (h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15620688"/>
        <c:crosses val="autoZero"/>
        <c:crossBetween val="midCat"/>
        <c:majorUnit val="12"/>
      </c:valAx>
      <c:valAx>
        <c:axId val="1315620688"/>
        <c:scaling>
          <c:orientation val="minMax"/>
          <c:max val="8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OD</a:t>
                </a:r>
                <a:r>
                  <a:rPr lang="en-US" baseline="-25000" dirty="0"/>
                  <a:t>600</a:t>
                </a:r>
                <a:endParaRPr lang="ja-JP" baseline="-2500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15623408"/>
        <c:crosses val="autoZero"/>
        <c:crossBetween val="midCat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OD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bg1">
                  <a:lumMod val="50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C$2:$C$25</c:f>
                <c:numCache>
                  <c:formatCode>General</c:formatCode>
                  <c:ptCount val="24"/>
                  <c:pt idx="0">
                    <c:v>4.533396743881471E-2</c:v>
                  </c:pt>
                  <c:pt idx="1">
                    <c:v>5.5265374863454376E-2</c:v>
                  </c:pt>
                  <c:pt idx="2">
                    <c:v>4.7422664223977465E-2</c:v>
                  </c:pt>
                  <c:pt idx="3">
                    <c:v>2.5487260100508013E-2</c:v>
                  </c:pt>
                  <c:pt idx="4">
                    <c:v>1.4054867885026469E-2</c:v>
                  </c:pt>
                  <c:pt idx="5">
                    <c:v>5.6219471540106231E-2</c:v>
                  </c:pt>
                  <c:pt idx="6">
                    <c:v>0.1155876089413883</c:v>
                  </c:pt>
                  <c:pt idx="7">
                    <c:v>0.75156906728392137</c:v>
                  </c:pt>
                  <c:pt idx="8">
                    <c:v>0.38762770546984143</c:v>
                  </c:pt>
                  <c:pt idx="9">
                    <c:v>0.56921547557801078</c:v>
                  </c:pt>
                  <c:pt idx="10">
                    <c:v>0.35797490207793586</c:v>
                  </c:pt>
                  <c:pt idx="11">
                    <c:v>0.37489387982805261</c:v>
                  </c:pt>
                </c:numCache>
              </c:numRef>
            </c:plus>
            <c:minus>
              <c:numRef>
                <c:f>Sheet1!$C$2:$C$25</c:f>
                <c:numCache>
                  <c:formatCode>General</c:formatCode>
                  <c:ptCount val="24"/>
                  <c:pt idx="0">
                    <c:v>4.533396743881471E-2</c:v>
                  </c:pt>
                  <c:pt idx="1">
                    <c:v>5.5265374863454376E-2</c:v>
                  </c:pt>
                  <c:pt idx="2">
                    <c:v>4.7422664223977465E-2</c:v>
                  </c:pt>
                  <c:pt idx="3">
                    <c:v>2.5487260100508013E-2</c:v>
                  </c:pt>
                  <c:pt idx="4">
                    <c:v>1.4054867885026469E-2</c:v>
                  </c:pt>
                  <c:pt idx="5">
                    <c:v>5.6219471540106231E-2</c:v>
                  </c:pt>
                  <c:pt idx="6">
                    <c:v>0.1155876089413883</c:v>
                  </c:pt>
                  <c:pt idx="7">
                    <c:v>0.75156906728392137</c:v>
                  </c:pt>
                  <c:pt idx="8">
                    <c:v>0.38762770546984143</c:v>
                  </c:pt>
                  <c:pt idx="9">
                    <c:v>0.56921547557801078</c:v>
                  </c:pt>
                  <c:pt idx="10">
                    <c:v>0.35797490207793586</c:v>
                  </c:pt>
                  <c:pt idx="11">
                    <c:v>0.37489387982805261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Sheet1!$A$2:$A$25</c:f>
              <c:numCache>
                <c:formatCode>General</c:formatCode>
                <c:ptCount val="24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.25</c:v>
                </c:pt>
                <c:pt idx="5">
                  <c:v>10</c:v>
                </c:pt>
                <c:pt idx="6">
                  <c:v>12</c:v>
                </c:pt>
                <c:pt idx="7">
                  <c:v>16</c:v>
                </c:pt>
                <c:pt idx="8">
                  <c:v>19.5</c:v>
                </c:pt>
                <c:pt idx="9">
                  <c:v>34</c:v>
                </c:pt>
                <c:pt idx="10">
                  <c:v>59</c:v>
                </c:pt>
                <c:pt idx="11">
                  <c:v>82</c:v>
                </c:pt>
              </c:numCache>
            </c:numRef>
          </c:xVal>
          <c:yVal>
            <c:numRef>
              <c:f>Sheet1!$B$2:$B$25</c:f>
              <c:numCache>
                <c:formatCode>General</c:formatCode>
                <c:ptCount val="24"/>
                <c:pt idx="0">
                  <c:v>-5.9640371229698362E-2</c:v>
                </c:pt>
                <c:pt idx="1">
                  <c:v>-3.3758700696055869E-3</c:v>
                </c:pt>
                <c:pt idx="2">
                  <c:v>-2.4756380510440917E-2</c:v>
                </c:pt>
                <c:pt idx="3">
                  <c:v>-2.7006960556844612E-2</c:v>
                </c:pt>
                <c:pt idx="4">
                  <c:v>1.1252900232018491E-2</c:v>
                </c:pt>
                <c:pt idx="5">
                  <c:v>0.45799303944315523</c:v>
                </c:pt>
                <c:pt idx="6">
                  <c:v>1.6598027842227374</c:v>
                </c:pt>
                <c:pt idx="7">
                  <c:v>3.0787935034802785</c:v>
                </c:pt>
                <c:pt idx="8">
                  <c:v>6.1902204176334097</c:v>
                </c:pt>
                <c:pt idx="9">
                  <c:v>10.476450116009277</c:v>
                </c:pt>
                <c:pt idx="10">
                  <c:v>10.808410672853826</c:v>
                </c:pt>
                <c:pt idx="11">
                  <c:v>11.0469721577726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473-454F-B55D-CFEA6309F36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15630480"/>
        <c:axId val="1315615792"/>
      </c:scatterChart>
      <c:valAx>
        <c:axId val="1315630480"/>
        <c:scaling>
          <c:orientation val="minMax"/>
          <c:max val="8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Cultivation time (h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15615792"/>
        <c:crosses val="autoZero"/>
        <c:crossBetween val="midCat"/>
        <c:majorUnit val="12"/>
      </c:valAx>
      <c:valAx>
        <c:axId val="1315615792"/>
        <c:scaling>
          <c:orientation val="minMax"/>
          <c:max val="14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OD</a:t>
                </a:r>
                <a:r>
                  <a:rPr lang="en-US" baseline="-25000" dirty="0"/>
                  <a:t>600</a:t>
                </a:r>
                <a:endParaRPr lang="ja-JP" baseline="-2500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15630480"/>
        <c:crosses val="autoZero"/>
        <c:crossBetween val="midCat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FD37FB2-13E6-4B5A-B9A4-3449ED32AE6F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16150" y="1233488"/>
            <a:ext cx="230346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748213"/>
            <a:ext cx="5389563" cy="38846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331E427-FAB1-44A5-8476-F8702B0FD9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09261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361E6-A0AF-4F16-9CE2-6CA3D5594F12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C32B4-E779-488F-83AC-75A47336EF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41754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361E6-A0AF-4F16-9CE2-6CA3D5594F12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C32B4-E779-488F-83AC-75A47336EF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48834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361E6-A0AF-4F16-9CE2-6CA3D5594F12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C32B4-E779-488F-83AC-75A47336EF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0092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361E6-A0AF-4F16-9CE2-6CA3D5594F12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C32B4-E779-488F-83AC-75A47336EF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10574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361E6-A0AF-4F16-9CE2-6CA3D5594F12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C32B4-E779-488F-83AC-75A47336EF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2679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361E6-A0AF-4F16-9CE2-6CA3D5594F12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C32B4-E779-488F-83AC-75A47336EF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2748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361E6-A0AF-4F16-9CE2-6CA3D5594F12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C32B4-E779-488F-83AC-75A47336EF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26843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361E6-A0AF-4F16-9CE2-6CA3D5594F12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C32B4-E779-488F-83AC-75A47336EF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53753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361E6-A0AF-4F16-9CE2-6CA3D5594F12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C32B4-E779-488F-83AC-75A47336EF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65110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361E6-A0AF-4F16-9CE2-6CA3D5594F12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C32B4-E779-488F-83AC-75A47336EF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5612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361E6-A0AF-4F16-9CE2-6CA3D5594F12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C32B4-E779-488F-83AC-75A47336EF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27779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2361E6-A0AF-4F16-9CE2-6CA3D5594F12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5C32B4-E779-488F-83AC-75A47336EF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34584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1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3.xml"/><Relationship Id="rId7" Type="http://schemas.openxmlformats.org/officeDocument/2006/relationships/chart" Target="../charts/chart17.xml"/><Relationship Id="rId2" Type="http://schemas.openxmlformats.org/officeDocument/2006/relationships/chart" Target="../charts/chart12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6.xml"/><Relationship Id="rId5" Type="http://schemas.openxmlformats.org/officeDocument/2006/relationships/chart" Target="../charts/chart15.xml"/><Relationship Id="rId4" Type="http://schemas.openxmlformats.org/officeDocument/2006/relationships/chart" Target="../charts/chart14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9.xml"/><Relationship Id="rId2" Type="http://schemas.openxmlformats.org/officeDocument/2006/relationships/chart" Target="../charts/chart18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グラフ 7"/>
          <p:cNvGraphicFramePr/>
          <p:nvPr>
            <p:extLst>
              <p:ext uri="{D42A27DB-BD31-4B8C-83A1-F6EECF244321}">
                <p14:modId xmlns:p14="http://schemas.microsoft.com/office/powerpoint/2010/main" val="3587116873"/>
              </p:ext>
            </p:extLst>
          </p:nvPr>
        </p:nvGraphicFramePr>
        <p:xfrm>
          <a:off x="765137" y="632339"/>
          <a:ext cx="2663867" cy="19039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5" name="グラフ 14"/>
          <p:cNvGraphicFramePr/>
          <p:nvPr>
            <p:extLst>
              <p:ext uri="{D42A27DB-BD31-4B8C-83A1-F6EECF244321}">
                <p14:modId xmlns:p14="http://schemas.microsoft.com/office/powerpoint/2010/main" val="2360799228"/>
              </p:ext>
            </p:extLst>
          </p:nvPr>
        </p:nvGraphicFramePr>
        <p:xfrm>
          <a:off x="3429004" y="632339"/>
          <a:ext cx="2663867" cy="19039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8" name="グラフ 17"/>
          <p:cNvGraphicFramePr/>
          <p:nvPr>
            <p:extLst>
              <p:ext uri="{D42A27DB-BD31-4B8C-83A1-F6EECF244321}">
                <p14:modId xmlns:p14="http://schemas.microsoft.com/office/powerpoint/2010/main" val="2303750261"/>
              </p:ext>
            </p:extLst>
          </p:nvPr>
        </p:nvGraphicFramePr>
        <p:xfrm>
          <a:off x="765137" y="2816927"/>
          <a:ext cx="2663867" cy="19039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9" name="グラフ 18"/>
          <p:cNvGraphicFramePr/>
          <p:nvPr>
            <p:extLst>
              <p:ext uri="{D42A27DB-BD31-4B8C-83A1-F6EECF244321}">
                <p14:modId xmlns:p14="http://schemas.microsoft.com/office/powerpoint/2010/main" val="3793177135"/>
              </p:ext>
            </p:extLst>
          </p:nvPr>
        </p:nvGraphicFramePr>
        <p:xfrm>
          <a:off x="3429004" y="2816927"/>
          <a:ext cx="2663867" cy="19039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2" name="グラフ 21"/>
          <p:cNvGraphicFramePr/>
          <p:nvPr>
            <p:extLst>
              <p:ext uri="{D42A27DB-BD31-4B8C-83A1-F6EECF244321}">
                <p14:modId xmlns:p14="http://schemas.microsoft.com/office/powerpoint/2010/main" val="864993747"/>
              </p:ext>
            </p:extLst>
          </p:nvPr>
        </p:nvGraphicFramePr>
        <p:xfrm>
          <a:off x="3499872" y="7775801"/>
          <a:ext cx="2663867" cy="19039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3" name="グラフ 22"/>
          <p:cNvGraphicFramePr/>
          <p:nvPr>
            <p:extLst>
              <p:ext uri="{D42A27DB-BD31-4B8C-83A1-F6EECF244321}">
                <p14:modId xmlns:p14="http://schemas.microsoft.com/office/powerpoint/2010/main" val="311843825"/>
              </p:ext>
            </p:extLst>
          </p:nvPr>
        </p:nvGraphicFramePr>
        <p:xfrm>
          <a:off x="748706" y="5223227"/>
          <a:ext cx="2663867" cy="19039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7" name="テキスト ボックス 6"/>
          <p:cNvSpPr txBox="1"/>
          <p:nvPr/>
        </p:nvSpPr>
        <p:spPr>
          <a:xfrm>
            <a:off x="1142422" y="286346"/>
            <a:ext cx="228658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Lacticaseibacillus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casei</a:t>
            </a:r>
            <a:b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JCM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1134</a:t>
            </a:r>
            <a:r>
              <a:rPr lang="en-US" altLang="ja-JP" sz="14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kumimoji="1" lang="ja-JP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3616434" y="259613"/>
            <a:ext cx="277120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Lacticaseibacillus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r>
              <a:rPr lang="en-US" altLang="ja-JP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rhamnosus</a:t>
            </a:r>
            <a:b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ATCC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7469</a:t>
            </a:r>
            <a:r>
              <a:rPr lang="en-US" altLang="ja-JP" sz="14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kumimoji="1" lang="ja-JP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174108" y="2529238"/>
            <a:ext cx="342747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Limosilactobacillus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r>
              <a:rPr lang="en-US" altLang="ja-JP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reuteri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ubsp.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r>
              <a:rPr lang="en-US" altLang="ja-JP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reuteri</a:t>
            </a:r>
            <a:b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JCM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1112</a:t>
            </a:r>
            <a:r>
              <a:rPr lang="en-US" altLang="ja-JP" sz="14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kumimoji="1" lang="ja-JP" altLang="en-US" sz="14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3532767" y="2524487"/>
            <a:ext cx="366813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Lactiplantibacillus plantarum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subsp. </a:t>
            </a:r>
            <a:r>
              <a:rPr lang="en-US" altLang="ja-JP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plantarum</a:t>
            </a:r>
            <a:endParaRPr lang="en-US" altLang="ja-JP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JCM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1149</a:t>
            </a:r>
            <a:r>
              <a:rPr kumimoji="1" lang="en-US" altLang="ja-JP" sz="14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kumimoji="1" lang="ja-JP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3968871" y="7365361"/>
            <a:ext cx="228658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Lactobacillus </a:t>
            </a:r>
            <a:r>
              <a:rPr lang="en-US" altLang="ja-JP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crispatus</a:t>
            </a:r>
            <a:b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JCM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1185</a:t>
            </a:r>
            <a:r>
              <a:rPr lang="en-US" altLang="ja-JP" sz="14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kumimoji="1" lang="ja-JP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1093769" y="4837953"/>
            <a:ext cx="228658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Ligilactobacillus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salivarius</a:t>
            </a:r>
            <a:b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JCM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1231</a:t>
            </a:r>
            <a:r>
              <a:rPr lang="en-US" altLang="ja-JP" sz="14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kumimoji="1" lang="ja-JP" altLang="en-US" sz="14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二等辺三角形 1"/>
          <p:cNvSpPr/>
          <p:nvPr/>
        </p:nvSpPr>
        <p:spPr>
          <a:xfrm rot="10800000">
            <a:off x="2603085" y="781404"/>
            <a:ext cx="66312" cy="91274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二等辺三角形 23"/>
          <p:cNvSpPr/>
          <p:nvPr/>
        </p:nvSpPr>
        <p:spPr>
          <a:xfrm rot="8533057">
            <a:off x="1611314" y="1502988"/>
            <a:ext cx="66312" cy="91274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二等辺三角形 24"/>
          <p:cNvSpPr/>
          <p:nvPr/>
        </p:nvSpPr>
        <p:spPr>
          <a:xfrm rot="8533057">
            <a:off x="4240495" y="1416987"/>
            <a:ext cx="66312" cy="91274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" name="二等辺三角形 26"/>
          <p:cNvSpPr/>
          <p:nvPr/>
        </p:nvSpPr>
        <p:spPr>
          <a:xfrm rot="10800000">
            <a:off x="5256652" y="862527"/>
            <a:ext cx="66312" cy="91274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二等辺三角形 27"/>
          <p:cNvSpPr/>
          <p:nvPr/>
        </p:nvSpPr>
        <p:spPr>
          <a:xfrm rot="8533057">
            <a:off x="1477515" y="3716111"/>
            <a:ext cx="66312" cy="91274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二等辺三角形 28"/>
          <p:cNvSpPr/>
          <p:nvPr/>
        </p:nvSpPr>
        <p:spPr>
          <a:xfrm rot="10800000">
            <a:off x="1805815" y="3134764"/>
            <a:ext cx="66312" cy="91274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二等辺三角形 29"/>
          <p:cNvSpPr/>
          <p:nvPr/>
        </p:nvSpPr>
        <p:spPr>
          <a:xfrm rot="10800000">
            <a:off x="4610712" y="3530087"/>
            <a:ext cx="66312" cy="91274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二等辺三角形 30"/>
          <p:cNvSpPr/>
          <p:nvPr/>
        </p:nvSpPr>
        <p:spPr>
          <a:xfrm rot="8533057">
            <a:off x="4177638" y="3719930"/>
            <a:ext cx="66312" cy="91274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" name="二等辺三角形 41"/>
          <p:cNvSpPr/>
          <p:nvPr/>
        </p:nvSpPr>
        <p:spPr>
          <a:xfrm rot="8533057">
            <a:off x="4401512" y="8656112"/>
            <a:ext cx="66312" cy="91274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" name="二等辺三角形 43"/>
          <p:cNvSpPr/>
          <p:nvPr/>
        </p:nvSpPr>
        <p:spPr>
          <a:xfrm rot="10800000">
            <a:off x="5019165" y="7908341"/>
            <a:ext cx="66312" cy="91274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5" name="二等辺三角形 44"/>
          <p:cNvSpPr/>
          <p:nvPr/>
        </p:nvSpPr>
        <p:spPr>
          <a:xfrm rot="10800000">
            <a:off x="2135460" y="5530246"/>
            <a:ext cx="66312" cy="91274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" name="二等辺三角形 45"/>
          <p:cNvSpPr/>
          <p:nvPr/>
        </p:nvSpPr>
        <p:spPr>
          <a:xfrm rot="8533057">
            <a:off x="1541938" y="5987558"/>
            <a:ext cx="66312" cy="91274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54" name="グループ化 53"/>
          <p:cNvGrpSpPr/>
          <p:nvPr/>
        </p:nvGrpSpPr>
        <p:grpSpPr>
          <a:xfrm>
            <a:off x="3489585" y="4931961"/>
            <a:ext cx="2663190" cy="2144836"/>
            <a:chOff x="469901" y="2576611"/>
            <a:chExt cx="2959099" cy="2383151"/>
          </a:xfrm>
        </p:grpSpPr>
        <p:graphicFrame>
          <p:nvGraphicFramePr>
            <p:cNvPr id="55" name="グラフ 54"/>
            <p:cNvGraphicFramePr/>
            <p:nvPr>
              <p:extLst>
                <p:ext uri="{D42A27DB-BD31-4B8C-83A1-F6EECF244321}">
                  <p14:modId xmlns:p14="http://schemas.microsoft.com/office/powerpoint/2010/main" val="363924246"/>
                </p:ext>
              </p:extLst>
            </p:nvPr>
          </p:nvGraphicFramePr>
          <p:xfrm>
            <a:off x="469901" y="2844800"/>
            <a:ext cx="2959099" cy="211496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56" name="テキスト ボックス 55"/>
            <p:cNvSpPr txBox="1"/>
            <p:nvPr/>
          </p:nvSpPr>
          <p:spPr>
            <a:xfrm>
              <a:off x="889000" y="2576611"/>
              <a:ext cx="2540000" cy="581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Lactobacillus </a:t>
              </a:r>
              <a:r>
                <a:rPr lang="en-US" altLang="ja-JP" sz="14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johnsonii</a:t>
              </a:r>
              <a:br>
                <a:rPr lang="en-US" altLang="ja-JP" sz="1400" i="1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altLang="ja-JP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JCM2012</a:t>
              </a:r>
              <a:r>
                <a:rPr lang="en-US" altLang="ja-JP" sz="14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endParaRPr kumimoji="1" lang="ja-JP" altLang="en-US" sz="14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7" name="二等辺三角形 56"/>
          <p:cNvSpPr/>
          <p:nvPr/>
        </p:nvSpPr>
        <p:spPr>
          <a:xfrm rot="10800000">
            <a:off x="4520592" y="5438189"/>
            <a:ext cx="66295" cy="9125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" name="二等辺三角形 57"/>
          <p:cNvSpPr/>
          <p:nvPr/>
        </p:nvSpPr>
        <p:spPr>
          <a:xfrm rot="8533057">
            <a:off x="4162838" y="6027730"/>
            <a:ext cx="66295" cy="91251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59" name="グループ化 58"/>
          <p:cNvGrpSpPr/>
          <p:nvPr/>
        </p:nvGrpSpPr>
        <p:grpSpPr>
          <a:xfrm>
            <a:off x="724298" y="7326177"/>
            <a:ext cx="2765287" cy="2222095"/>
            <a:chOff x="356460" y="208305"/>
            <a:chExt cx="3072540" cy="2468995"/>
          </a:xfrm>
        </p:grpSpPr>
        <p:graphicFrame>
          <p:nvGraphicFramePr>
            <p:cNvPr id="60" name="グラフ 59"/>
            <p:cNvGraphicFramePr/>
            <p:nvPr>
              <p:extLst>
                <p:ext uri="{D42A27DB-BD31-4B8C-83A1-F6EECF244321}">
                  <p14:modId xmlns:p14="http://schemas.microsoft.com/office/powerpoint/2010/main" val="255722248"/>
                </p:ext>
              </p:extLst>
            </p:nvPr>
          </p:nvGraphicFramePr>
          <p:xfrm>
            <a:off x="356460" y="562336"/>
            <a:ext cx="2959099" cy="211496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sp>
          <p:nvSpPr>
            <p:cNvPr id="61" name="テキスト ボックス 60"/>
            <p:cNvSpPr txBox="1"/>
            <p:nvPr/>
          </p:nvSpPr>
          <p:spPr>
            <a:xfrm>
              <a:off x="889000" y="208305"/>
              <a:ext cx="2540000" cy="581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Lactobacillus acidophilus</a:t>
              </a:r>
              <a:br>
                <a:rPr lang="en-US" altLang="ja-JP" sz="1400" i="1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altLang="ja-JP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JCM1132</a:t>
              </a:r>
              <a:r>
                <a:rPr lang="en-US" altLang="ja-JP" sz="14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endParaRPr kumimoji="1" lang="ja-JP" altLang="en-US" sz="14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2" name="二等辺三角形 61"/>
          <p:cNvSpPr/>
          <p:nvPr/>
        </p:nvSpPr>
        <p:spPr>
          <a:xfrm rot="8187657">
            <a:off x="1524128" y="8535516"/>
            <a:ext cx="66295" cy="91251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3" name="二等辺三角形 62"/>
          <p:cNvSpPr/>
          <p:nvPr/>
        </p:nvSpPr>
        <p:spPr>
          <a:xfrm rot="10800000">
            <a:off x="2560174" y="8141675"/>
            <a:ext cx="66295" cy="9125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-73288" y="-42512"/>
            <a:ext cx="152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solidFill>
                  <a:srgbClr val="FF0000"/>
                </a:solidFill>
                <a:latin typeface="Calibri" panose="020F0502020204030204" pitchFamily="34" charset="0"/>
              </a:rPr>
              <a:t>Figure </a:t>
            </a:r>
            <a:r>
              <a:rPr kumimoji="1" lang="en-US" altLang="ja-JP" sz="1600" dirty="0" err="1">
                <a:solidFill>
                  <a:srgbClr val="FF0000"/>
                </a:solidFill>
                <a:latin typeface="Calibri" panose="020F0502020204030204" pitchFamily="34" charset="0"/>
              </a:rPr>
              <a:t>S1</a:t>
            </a:r>
            <a:endParaRPr kumimoji="1" lang="ja-JP" altLang="en-US" sz="1600" dirty="0">
              <a:solidFill>
                <a:srgbClr val="FF0000"/>
              </a:solidFill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05687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グラフ 14"/>
          <p:cNvGraphicFramePr/>
          <p:nvPr>
            <p:extLst>
              <p:ext uri="{D42A27DB-BD31-4B8C-83A1-F6EECF244321}">
                <p14:modId xmlns:p14="http://schemas.microsoft.com/office/powerpoint/2010/main" val="425267270"/>
              </p:ext>
            </p:extLst>
          </p:nvPr>
        </p:nvGraphicFramePr>
        <p:xfrm>
          <a:off x="765809" y="2708840"/>
          <a:ext cx="2663190" cy="19034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3" name="二等辺三角形 22"/>
          <p:cNvSpPr/>
          <p:nvPr/>
        </p:nvSpPr>
        <p:spPr>
          <a:xfrm rot="8533057">
            <a:off x="1642488" y="3612519"/>
            <a:ext cx="66295" cy="91251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二等辺三角形 24"/>
          <p:cNvSpPr/>
          <p:nvPr/>
        </p:nvSpPr>
        <p:spPr>
          <a:xfrm rot="10800000">
            <a:off x="2647593" y="2916140"/>
            <a:ext cx="66295" cy="9125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1142999" y="2461831"/>
            <a:ext cx="228658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Latilactobacillus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curvatus</a:t>
            </a:r>
            <a:b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K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3-4</a:t>
            </a:r>
            <a:endParaRPr kumimoji="1" lang="ja-JP" alt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8" name="グラフ 27"/>
          <p:cNvGraphicFramePr/>
          <p:nvPr>
            <p:extLst>
              <p:ext uri="{D42A27DB-BD31-4B8C-83A1-F6EECF244321}">
                <p14:modId xmlns:p14="http://schemas.microsoft.com/office/powerpoint/2010/main" val="2915226821"/>
              </p:ext>
            </p:extLst>
          </p:nvPr>
        </p:nvGraphicFramePr>
        <p:xfrm>
          <a:off x="765132" y="297424"/>
          <a:ext cx="2663867" cy="19039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9" name="グラフ 28"/>
          <p:cNvGraphicFramePr/>
          <p:nvPr>
            <p:extLst>
              <p:ext uri="{D42A27DB-BD31-4B8C-83A1-F6EECF244321}">
                <p14:modId xmlns:p14="http://schemas.microsoft.com/office/powerpoint/2010/main" val="1752584213"/>
              </p:ext>
            </p:extLst>
          </p:nvPr>
        </p:nvGraphicFramePr>
        <p:xfrm>
          <a:off x="3439832" y="315397"/>
          <a:ext cx="2663867" cy="19039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7" name="テキスト ボックス 36"/>
          <p:cNvSpPr txBox="1"/>
          <p:nvPr/>
        </p:nvSpPr>
        <p:spPr>
          <a:xfrm>
            <a:off x="1142416" y="85473"/>
            <a:ext cx="228658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Latilactobacillus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curvatus</a:t>
            </a:r>
            <a:b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JCM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1096</a:t>
            </a:r>
            <a:r>
              <a:rPr lang="en-US" altLang="ja-JP" sz="14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kumimoji="1" lang="ja-JP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3784895" y="103446"/>
            <a:ext cx="228658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Latilactobacillus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curvatus</a:t>
            </a:r>
            <a:b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JCM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1091</a:t>
            </a:r>
            <a:endParaRPr kumimoji="1" lang="ja-JP" alt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二等辺三角形 38"/>
          <p:cNvSpPr/>
          <p:nvPr/>
        </p:nvSpPr>
        <p:spPr>
          <a:xfrm rot="8533057">
            <a:off x="1553108" y="1091957"/>
            <a:ext cx="66312" cy="91274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0" name="二等辺三角形 39"/>
          <p:cNvSpPr/>
          <p:nvPr/>
        </p:nvSpPr>
        <p:spPr>
          <a:xfrm rot="10800000">
            <a:off x="2285872" y="842564"/>
            <a:ext cx="66312" cy="91274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" name="二等辺三角形 40"/>
          <p:cNvSpPr/>
          <p:nvPr/>
        </p:nvSpPr>
        <p:spPr>
          <a:xfrm rot="10800000">
            <a:off x="4952653" y="885937"/>
            <a:ext cx="66312" cy="91274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" name="二等辺三角形 41"/>
          <p:cNvSpPr/>
          <p:nvPr/>
        </p:nvSpPr>
        <p:spPr>
          <a:xfrm rot="8533057">
            <a:off x="4192225" y="1218648"/>
            <a:ext cx="66312" cy="91274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-73288" y="-42512"/>
            <a:ext cx="152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solidFill>
                  <a:srgbClr val="FF0000"/>
                </a:solidFill>
                <a:latin typeface="Calibri" panose="020F0502020204030204" pitchFamily="34" charset="0"/>
              </a:rPr>
              <a:t>Figure </a:t>
            </a:r>
            <a:r>
              <a:rPr kumimoji="1" lang="en-US" altLang="ja-JP" sz="1600" dirty="0" err="1">
                <a:solidFill>
                  <a:srgbClr val="FF0000"/>
                </a:solidFill>
                <a:latin typeface="Calibri" panose="020F0502020204030204" pitchFamily="34" charset="0"/>
              </a:rPr>
              <a:t>S1</a:t>
            </a:r>
            <a:endParaRPr kumimoji="1" lang="ja-JP" altLang="en-US" sz="1600" dirty="0">
              <a:solidFill>
                <a:srgbClr val="FF0000"/>
              </a:solidFill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322567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テキスト ボックス 30"/>
          <p:cNvSpPr txBox="1"/>
          <p:nvPr/>
        </p:nvSpPr>
        <p:spPr>
          <a:xfrm>
            <a:off x="115834" y="175030"/>
            <a:ext cx="6292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400" dirty="0">
                <a:latin typeface="Calibri" panose="020F050202020403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A</a:t>
            </a:r>
            <a:endParaRPr lang="ja-JP" altLang="en-US" sz="2400" dirty="0">
              <a:latin typeface="Calibri" panose="020F050202020403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2324933" y="175030"/>
            <a:ext cx="6292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400" dirty="0">
                <a:latin typeface="Calibri" panose="020F050202020403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B</a:t>
            </a:r>
            <a:endParaRPr lang="ja-JP" altLang="en-US" sz="2400" dirty="0">
              <a:latin typeface="Calibri" panose="020F050202020403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graphicFrame>
        <p:nvGraphicFramePr>
          <p:cNvPr id="29" name="グラフ 28"/>
          <p:cNvGraphicFramePr/>
          <p:nvPr>
            <p:extLst>
              <p:ext uri="{D42A27DB-BD31-4B8C-83A1-F6EECF244321}">
                <p14:modId xmlns:p14="http://schemas.microsoft.com/office/powerpoint/2010/main" val="920670501"/>
              </p:ext>
            </p:extLst>
          </p:nvPr>
        </p:nvGraphicFramePr>
        <p:xfrm>
          <a:off x="330449" y="541194"/>
          <a:ext cx="1944000" cy="20227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9" name="テキスト ボックス 38"/>
          <p:cNvSpPr txBox="1"/>
          <p:nvPr/>
        </p:nvSpPr>
        <p:spPr>
          <a:xfrm>
            <a:off x="-36410" y="-94719"/>
            <a:ext cx="152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solidFill>
                  <a:srgbClr val="FF0000"/>
                </a:solidFill>
                <a:latin typeface="Calibri" panose="020F0502020204030204" pitchFamily="34" charset="0"/>
              </a:rPr>
              <a:t>Figure </a:t>
            </a:r>
            <a:r>
              <a:rPr kumimoji="1" lang="en-US" altLang="ja-JP" sz="1600" dirty="0" err="1">
                <a:solidFill>
                  <a:srgbClr val="FF0000"/>
                </a:solidFill>
                <a:latin typeface="Calibri" panose="020F0502020204030204" pitchFamily="34" charset="0"/>
              </a:rPr>
              <a:t>S2</a:t>
            </a:r>
            <a:endParaRPr kumimoji="1" lang="ja-JP" altLang="en-US" sz="1600" dirty="0">
              <a:solidFill>
                <a:srgbClr val="FF0000"/>
              </a:solidFill>
              <a:latin typeface="Calibri" panose="020F0502020204030204" pitchFamily="34" charset="0"/>
            </a:endParaRPr>
          </a:p>
        </p:txBody>
      </p:sp>
      <p:graphicFrame>
        <p:nvGraphicFramePr>
          <p:cNvPr id="40" name="グラフ 39"/>
          <p:cNvGraphicFramePr/>
          <p:nvPr>
            <p:extLst>
              <p:ext uri="{D42A27DB-BD31-4B8C-83A1-F6EECF244321}">
                <p14:modId xmlns:p14="http://schemas.microsoft.com/office/powerpoint/2010/main" val="1392026152"/>
              </p:ext>
            </p:extLst>
          </p:nvPr>
        </p:nvGraphicFramePr>
        <p:xfrm>
          <a:off x="2574525" y="541194"/>
          <a:ext cx="1944000" cy="20227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3" name="表 4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44382027"/>
              </p:ext>
            </p:extLst>
          </p:nvPr>
        </p:nvGraphicFramePr>
        <p:xfrm>
          <a:off x="5338109" y="2277908"/>
          <a:ext cx="1440000" cy="136199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80000">
                  <a:extLst>
                    <a:ext uri="{9D8B030D-6E8A-4147-A177-3AD203B41FA5}">
                      <a16:colId xmlns:a16="http://schemas.microsoft.com/office/drawing/2014/main" val="3219502552"/>
                    </a:ext>
                  </a:extLst>
                </a:gridCol>
                <a:gridCol w="480000">
                  <a:extLst>
                    <a:ext uri="{9D8B030D-6E8A-4147-A177-3AD203B41FA5}">
                      <a16:colId xmlns:a16="http://schemas.microsoft.com/office/drawing/2014/main" val="3189203486"/>
                    </a:ext>
                  </a:extLst>
                </a:gridCol>
                <a:gridCol w="480000">
                  <a:extLst>
                    <a:ext uri="{9D8B030D-6E8A-4147-A177-3AD203B41FA5}">
                      <a16:colId xmlns:a16="http://schemas.microsoft.com/office/drawing/2014/main" val="1391991627"/>
                    </a:ext>
                  </a:extLst>
                </a:gridCol>
              </a:tblGrid>
              <a:tr h="1361997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b="1" baseline="0" dirty="0" err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明朝" panose="02020609040205080304" pitchFamily="17" charset="-128"/>
                          <a:cs typeface="Calibri" panose="020F0502020204030204" pitchFamily="34" charset="0"/>
                        </a:rPr>
                        <a:t>MRS</a:t>
                      </a:r>
                      <a:r>
                        <a:rPr kumimoji="1" lang="en-US" altLang="ja-JP" sz="1400" b="1" baseline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明朝" panose="02020609040205080304" pitchFamily="17" charset="-128"/>
                          <a:cs typeface="Calibri" panose="020F0502020204030204" pitchFamily="34" charset="0"/>
                        </a:rPr>
                        <a:t> medium</a:t>
                      </a:r>
                    </a:p>
                  </a:txBody>
                  <a:tcPr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b="1" baseline="0" dirty="0" err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明朝" panose="02020609040205080304" pitchFamily="17" charset="-128"/>
                          <a:cs typeface="Calibri" panose="020F0502020204030204" pitchFamily="34" charset="0"/>
                        </a:rPr>
                        <a:t>10h</a:t>
                      </a:r>
                      <a:endParaRPr kumimoji="1" lang="en-US" altLang="ja-JP" sz="1400" b="1" baseline="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明朝" panose="02020609040205080304" pitchFamily="17" charset="-128"/>
                        <a:cs typeface="Calibri" panose="020F0502020204030204" pitchFamily="34" charset="0"/>
                      </a:endParaRPr>
                    </a:p>
                  </a:txBody>
                  <a:tcPr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400" dirty="0" err="1">
                          <a:solidFill>
                            <a:schemeClr val="tx1"/>
                          </a:solidFill>
                        </a:rPr>
                        <a:t>30h</a:t>
                      </a:r>
                      <a:r>
                        <a:rPr lang="ja-JP" altLang="en-US" sz="1400" dirty="0">
                          <a:solidFill>
                            <a:schemeClr val="tx1"/>
                          </a:solidFill>
                        </a:rPr>
                        <a:t> </a:t>
                      </a:r>
                      <a:endParaRPr kumimoji="1" lang="ja-JP" altLang="en-US" sz="1400" b="0" baseline="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明朝" panose="02020609040205080304" pitchFamily="17" charset="-128"/>
                        <a:cs typeface="Calibri" panose="020F0502020204030204" pitchFamily="34" charset="0"/>
                      </a:endParaRPr>
                    </a:p>
                  </a:txBody>
                  <a:tcPr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7657269"/>
                  </a:ext>
                </a:extLst>
              </a:tr>
            </a:tbl>
          </a:graphicData>
        </a:graphic>
      </p:graphicFrame>
      <p:sp>
        <p:nvSpPr>
          <p:cNvPr id="49" name="テキスト ボックス 48"/>
          <p:cNvSpPr txBox="1"/>
          <p:nvPr/>
        </p:nvSpPr>
        <p:spPr>
          <a:xfrm>
            <a:off x="4534033" y="175030"/>
            <a:ext cx="6292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400" dirty="0">
                <a:latin typeface="Calibri" panose="020F050202020403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C</a:t>
            </a:r>
            <a:endParaRPr lang="ja-JP" altLang="en-US" sz="2400" dirty="0">
              <a:latin typeface="Calibri" panose="020F050202020403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graphicFrame>
        <p:nvGraphicFramePr>
          <p:cNvPr id="50" name="グラフ 49"/>
          <p:cNvGraphicFramePr/>
          <p:nvPr>
            <p:extLst>
              <p:ext uri="{D42A27DB-BD31-4B8C-83A1-F6EECF244321}">
                <p14:modId xmlns:p14="http://schemas.microsoft.com/office/powerpoint/2010/main" val="1448032287"/>
              </p:ext>
            </p:extLst>
          </p:nvPr>
        </p:nvGraphicFramePr>
        <p:xfrm>
          <a:off x="4818601" y="541194"/>
          <a:ext cx="1944000" cy="20227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3" name="テキスト ボックス 52"/>
          <p:cNvSpPr txBox="1"/>
          <p:nvPr/>
        </p:nvSpPr>
        <p:spPr>
          <a:xfrm rot="16200000">
            <a:off x="-335685" y="1241865"/>
            <a:ext cx="152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Calibri" panose="020F0502020204030204" pitchFamily="34" charset="0"/>
              </a:rPr>
              <a:t>Putrescine (</a:t>
            </a:r>
            <a:r>
              <a:rPr kumimoji="1" lang="en-US" altLang="ja-JP" sz="1200" dirty="0" err="1">
                <a:latin typeface="Calibri" panose="020F0502020204030204" pitchFamily="34" charset="0"/>
              </a:rPr>
              <a:t>μM</a:t>
            </a:r>
            <a:r>
              <a:rPr kumimoji="1" lang="en-US" altLang="ja-JP" sz="1200" dirty="0">
                <a:latin typeface="Calibri" panose="020F0502020204030204" pitchFamily="34" charset="0"/>
              </a:rPr>
              <a:t>)</a:t>
            </a:r>
            <a:endParaRPr kumimoji="1" lang="ja-JP" altLang="en-US" sz="1200" dirty="0">
              <a:latin typeface="Calibri" panose="020F0502020204030204" pitchFamily="34" charset="0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 rot="16200000">
            <a:off x="1880953" y="1303726"/>
            <a:ext cx="152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Calibri" panose="020F0502020204030204" pitchFamily="34" charset="0"/>
              </a:rPr>
              <a:t>Spermidine</a:t>
            </a:r>
            <a:r>
              <a:rPr kumimoji="1" lang="en-US" altLang="ja-JP" sz="1200" dirty="0">
                <a:latin typeface="Calibri" panose="020F0502020204030204" pitchFamily="34" charset="0"/>
              </a:rPr>
              <a:t> (</a:t>
            </a:r>
            <a:r>
              <a:rPr kumimoji="1" lang="en-US" altLang="ja-JP" sz="1200" dirty="0" err="1">
                <a:latin typeface="Calibri" panose="020F0502020204030204" pitchFamily="34" charset="0"/>
              </a:rPr>
              <a:t>μM</a:t>
            </a:r>
            <a:r>
              <a:rPr kumimoji="1" lang="en-US" altLang="ja-JP" sz="1200" dirty="0">
                <a:latin typeface="Calibri" panose="020F0502020204030204" pitchFamily="34" charset="0"/>
              </a:rPr>
              <a:t>)</a:t>
            </a:r>
            <a:endParaRPr kumimoji="1" lang="ja-JP" altLang="en-US" sz="1200" dirty="0">
              <a:latin typeface="Calibri" panose="020F0502020204030204" pitchFamily="34" charset="0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 rot="16200000">
            <a:off x="4056601" y="1266578"/>
            <a:ext cx="152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>
                <a:latin typeface="Calibri" panose="020F0502020204030204" pitchFamily="34" charset="0"/>
              </a:rPr>
              <a:t>Spermine</a:t>
            </a:r>
            <a:r>
              <a:rPr kumimoji="1" lang="en-US" altLang="ja-JP" sz="1200" dirty="0">
                <a:latin typeface="Calibri" panose="020F0502020204030204" pitchFamily="34" charset="0"/>
              </a:rPr>
              <a:t> (</a:t>
            </a:r>
            <a:r>
              <a:rPr kumimoji="1" lang="en-US" altLang="ja-JP" sz="1200" dirty="0" err="1">
                <a:latin typeface="Calibri" panose="020F0502020204030204" pitchFamily="34" charset="0"/>
              </a:rPr>
              <a:t>μM</a:t>
            </a:r>
            <a:r>
              <a:rPr kumimoji="1" lang="en-US" altLang="ja-JP" sz="1200" dirty="0">
                <a:latin typeface="Calibri" panose="020F0502020204030204" pitchFamily="34" charset="0"/>
              </a:rPr>
              <a:t>)</a:t>
            </a:r>
            <a:endParaRPr kumimoji="1" lang="ja-JP" altLang="en-US" sz="1200" dirty="0">
              <a:latin typeface="Calibri" panose="020F0502020204030204" pitchFamily="34" charset="0"/>
            </a:endParaRPr>
          </a:p>
        </p:txBody>
      </p:sp>
      <p:graphicFrame>
        <p:nvGraphicFramePr>
          <p:cNvPr id="56" name="表 5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11922762"/>
              </p:ext>
            </p:extLst>
          </p:nvPr>
        </p:nvGraphicFramePr>
        <p:xfrm>
          <a:off x="3094033" y="2277907"/>
          <a:ext cx="1440000" cy="136199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80000">
                  <a:extLst>
                    <a:ext uri="{9D8B030D-6E8A-4147-A177-3AD203B41FA5}">
                      <a16:colId xmlns:a16="http://schemas.microsoft.com/office/drawing/2014/main" val="3219502552"/>
                    </a:ext>
                  </a:extLst>
                </a:gridCol>
                <a:gridCol w="480000">
                  <a:extLst>
                    <a:ext uri="{9D8B030D-6E8A-4147-A177-3AD203B41FA5}">
                      <a16:colId xmlns:a16="http://schemas.microsoft.com/office/drawing/2014/main" val="3189203486"/>
                    </a:ext>
                  </a:extLst>
                </a:gridCol>
                <a:gridCol w="480000">
                  <a:extLst>
                    <a:ext uri="{9D8B030D-6E8A-4147-A177-3AD203B41FA5}">
                      <a16:colId xmlns:a16="http://schemas.microsoft.com/office/drawing/2014/main" val="1391991627"/>
                    </a:ext>
                  </a:extLst>
                </a:gridCol>
              </a:tblGrid>
              <a:tr h="1361997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b="1" baseline="0" dirty="0" err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明朝" panose="02020609040205080304" pitchFamily="17" charset="-128"/>
                          <a:cs typeface="Calibri" panose="020F0502020204030204" pitchFamily="34" charset="0"/>
                        </a:rPr>
                        <a:t>MRS</a:t>
                      </a:r>
                      <a:r>
                        <a:rPr kumimoji="1" lang="en-US" altLang="ja-JP" sz="1400" b="1" baseline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明朝" panose="02020609040205080304" pitchFamily="17" charset="-128"/>
                          <a:cs typeface="Calibri" panose="020F0502020204030204" pitchFamily="34" charset="0"/>
                        </a:rPr>
                        <a:t> medium</a:t>
                      </a:r>
                    </a:p>
                  </a:txBody>
                  <a:tcPr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b="1" baseline="0" dirty="0" err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明朝" panose="02020609040205080304" pitchFamily="17" charset="-128"/>
                          <a:cs typeface="Calibri" panose="020F0502020204030204" pitchFamily="34" charset="0"/>
                        </a:rPr>
                        <a:t>10h</a:t>
                      </a:r>
                      <a:endParaRPr kumimoji="1" lang="en-US" altLang="ja-JP" sz="1400" b="1" baseline="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明朝" panose="02020609040205080304" pitchFamily="17" charset="-128"/>
                        <a:cs typeface="Calibri" panose="020F0502020204030204" pitchFamily="34" charset="0"/>
                      </a:endParaRPr>
                    </a:p>
                  </a:txBody>
                  <a:tcPr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400" dirty="0" err="1">
                          <a:solidFill>
                            <a:schemeClr val="tx1"/>
                          </a:solidFill>
                        </a:rPr>
                        <a:t>30h</a:t>
                      </a:r>
                      <a:r>
                        <a:rPr lang="ja-JP" altLang="en-US" sz="1400" dirty="0">
                          <a:solidFill>
                            <a:schemeClr val="tx1"/>
                          </a:solidFill>
                        </a:rPr>
                        <a:t> </a:t>
                      </a:r>
                      <a:endParaRPr kumimoji="1" lang="ja-JP" altLang="en-US" sz="1400" b="0" baseline="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明朝" panose="02020609040205080304" pitchFamily="17" charset="-128"/>
                        <a:cs typeface="Calibri" panose="020F0502020204030204" pitchFamily="34" charset="0"/>
                      </a:endParaRPr>
                    </a:p>
                  </a:txBody>
                  <a:tcPr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7657269"/>
                  </a:ext>
                </a:extLst>
              </a:tr>
            </a:tbl>
          </a:graphicData>
        </a:graphic>
      </p:graphicFrame>
      <p:graphicFrame>
        <p:nvGraphicFramePr>
          <p:cNvPr id="57" name="表 5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97211958"/>
              </p:ext>
            </p:extLst>
          </p:nvPr>
        </p:nvGraphicFramePr>
        <p:xfrm>
          <a:off x="846806" y="2277907"/>
          <a:ext cx="1440000" cy="136199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80000">
                  <a:extLst>
                    <a:ext uri="{9D8B030D-6E8A-4147-A177-3AD203B41FA5}">
                      <a16:colId xmlns:a16="http://schemas.microsoft.com/office/drawing/2014/main" val="3219502552"/>
                    </a:ext>
                  </a:extLst>
                </a:gridCol>
                <a:gridCol w="480000">
                  <a:extLst>
                    <a:ext uri="{9D8B030D-6E8A-4147-A177-3AD203B41FA5}">
                      <a16:colId xmlns:a16="http://schemas.microsoft.com/office/drawing/2014/main" val="3189203486"/>
                    </a:ext>
                  </a:extLst>
                </a:gridCol>
                <a:gridCol w="480000">
                  <a:extLst>
                    <a:ext uri="{9D8B030D-6E8A-4147-A177-3AD203B41FA5}">
                      <a16:colId xmlns:a16="http://schemas.microsoft.com/office/drawing/2014/main" val="1391991627"/>
                    </a:ext>
                  </a:extLst>
                </a:gridCol>
              </a:tblGrid>
              <a:tr h="1361997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b="1" baseline="0" dirty="0" err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明朝" panose="02020609040205080304" pitchFamily="17" charset="-128"/>
                          <a:cs typeface="Calibri" panose="020F0502020204030204" pitchFamily="34" charset="0"/>
                        </a:rPr>
                        <a:t>MRS</a:t>
                      </a:r>
                      <a:r>
                        <a:rPr kumimoji="1" lang="en-US" altLang="ja-JP" sz="1400" b="1" baseline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明朝" panose="02020609040205080304" pitchFamily="17" charset="-128"/>
                          <a:cs typeface="Calibri" panose="020F0502020204030204" pitchFamily="34" charset="0"/>
                        </a:rPr>
                        <a:t> medium</a:t>
                      </a:r>
                    </a:p>
                  </a:txBody>
                  <a:tcPr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b="1" baseline="0" dirty="0" err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明朝" panose="02020609040205080304" pitchFamily="17" charset="-128"/>
                          <a:cs typeface="Calibri" panose="020F0502020204030204" pitchFamily="34" charset="0"/>
                        </a:rPr>
                        <a:t>10h</a:t>
                      </a:r>
                      <a:endParaRPr kumimoji="1" lang="en-US" altLang="ja-JP" sz="1400" b="1" baseline="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明朝" panose="02020609040205080304" pitchFamily="17" charset="-128"/>
                        <a:cs typeface="Calibri" panose="020F0502020204030204" pitchFamily="34" charset="0"/>
                      </a:endParaRPr>
                    </a:p>
                  </a:txBody>
                  <a:tcPr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400" dirty="0" err="1">
                          <a:solidFill>
                            <a:schemeClr val="tx1"/>
                          </a:solidFill>
                        </a:rPr>
                        <a:t>30h</a:t>
                      </a:r>
                      <a:r>
                        <a:rPr lang="ja-JP" altLang="en-US" sz="1400" dirty="0">
                          <a:solidFill>
                            <a:schemeClr val="tx1"/>
                          </a:solidFill>
                        </a:rPr>
                        <a:t> </a:t>
                      </a:r>
                      <a:endParaRPr kumimoji="1" lang="ja-JP" altLang="en-US" sz="1400" b="0" baseline="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明朝" panose="02020609040205080304" pitchFamily="17" charset="-128"/>
                        <a:cs typeface="Calibri" panose="020F0502020204030204" pitchFamily="34" charset="0"/>
                      </a:endParaRPr>
                    </a:p>
                  </a:txBody>
                  <a:tcPr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7657269"/>
                  </a:ext>
                </a:extLst>
              </a:tr>
            </a:tbl>
          </a:graphicData>
        </a:graphic>
      </p:graphicFrame>
      <p:sp>
        <p:nvSpPr>
          <p:cNvPr id="58" name="テキスト ボックス 57"/>
          <p:cNvSpPr txBox="1"/>
          <p:nvPr/>
        </p:nvSpPr>
        <p:spPr>
          <a:xfrm>
            <a:off x="2353765" y="3738247"/>
            <a:ext cx="6292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400" dirty="0">
                <a:latin typeface="Calibri" panose="020F050202020403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E</a:t>
            </a:r>
            <a:endParaRPr lang="ja-JP" altLang="en-US" sz="2400" dirty="0">
              <a:latin typeface="Calibri" panose="020F050202020403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graphicFrame>
        <p:nvGraphicFramePr>
          <p:cNvPr id="62" name="グラフ 61"/>
          <p:cNvGraphicFramePr/>
          <p:nvPr>
            <p:extLst>
              <p:ext uri="{D42A27DB-BD31-4B8C-83A1-F6EECF244321}">
                <p14:modId xmlns:p14="http://schemas.microsoft.com/office/powerpoint/2010/main" val="765230720"/>
              </p:ext>
            </p:extLst>
          </p:nvPr>
        </p:nvGraphicFramePr>
        <p:xfrm>
          <a:off x="2603357" y="4104411"/>
          <a:ext cx="1944000" cy="20227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7" name="テキスト ボックス 66"/>
          <p:cNvSpPr txBox="1"/>
          <p:nvPr/>
        </p:nvSpPr>
        <p:spPr>
          <a:xfrm>
            <a:off x="4562865" y="3738247"/>
            <a:ext cx="6292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400" dirty="0">
                <a:latin typeface="Calibri" panose="020F050202020403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F</a:t>
            </a:r>
            <a:endParaRPr lang="ja-JP" altLang="en-US" sz="2400" dirty="0">
              <a:latin typeface="Calibri" panose="020F050202020403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graphicFrame>
        <p:nvGraphicFramePr>
          <p:cNvPr id="71" name="表 7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34302833"/>
              </p:ext>
            </p:extLst>
          </p:nvPr>
        </p:nvGraphicFramePr>
        <p:xfrm>
          <a:off x="3110506" y="5841124"/>
          <a:ext cx="1464904" cy="136199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32452">
                  <a:extLst>
                    <a:ext uri="{9D8B030D-6E8A-4147-A177-3AD203B41FA5}">
                      <a16:colId xmlns:a16="http://schemas.microsoft.com/office/drawing/2014/main" val="3189203486"/>
                    </a:ext>
                  </a:extLst>
                </a:gridCol>
                <a:gridCol w="732452">
                  <a:extLst>
                    <a:ext uri="{9D8B030D-6E8A-4147-A177-3AD203B41FA5}">
                      <a16:colId xmlns:a16="http://schemas.microsoft.com/office/drawing/2014/main" val="1391991627"/>
                    </a:ext>
                  </a:extLst>
                </a:gridCol>
              </a:tblGrid>
              <a:tr h="1361997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b="1" baseline="0" dirty="0" err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明朝" panose="02020609040205080304" pitchFamily="17" charset="-128"/>
                          <a:cs typeface="Calibri" panose="020F0502020204030204" pitchFamily="34" charset="0"/>
                        </a:rPr>
                        <a:t>10h</a:t>
                      </a:r>
                      <a:endParaRPr kumimoji="1" lang="en-US" altLang="ja-JP" sz="1400" b="1" baseline="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明朝" panose="02020609040205080304" pitchFamily="17" charset="-128"/>
                        <a:cs typeface="Calibri" panose="020F0502020204030204" pitchFamily="34" charset="0"/>
                      </a:endParaRPr>
                    </a:p>
                  </a:txBody>
                  <a:tcPr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400" dirty="0" err="1">
                          <a:solidFill>
                            <a:schemeClr val="tx1"/>
                          </a:solidFill>
                        </a:rPr>
                        <a:t>30h</a:t>
                      </a:r>
                      <a:r>
                        <a:rPr lang="ja-JP" altLang="en-US" sz="1400" dirty="0">
                          <a:solidFill>
                            <a:schemeClr val="tx1"/>
                          </a:solidFill>
                        </a:rPr>
                        <a:t> </a:t>
                      </a:r>
                      <a:endParaRPr kumimoji="1" lang="ja-JP" altLang="en-US" sz="1400" b="0" baseline="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明朝" panose="02020609040205080304" pitchFamily="17" charset="-128"/>
                        <a:cs typeface="Calibri" panose="020F0502020204030204" pitchFamily="34" charset="0"/>
                      </a:endParaRPr>
                    </a:p>
                  </a:txBody>
                  <a:tcPr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7657269"/>
                  </a:ext>
                </a:extLst>
              </a:tr>
            </a:tbl>
          </a:graphicData>
        </a:graphic>
      </p:graphicFrame>
      <p:sp>
        <p:nvSpPr>
          <p:cNvPr id="72" name="テキスト ボックス 71"/>
          <p:cNvSpPr txBox="1"/>
          <p:nvPr/>
        </p:nvSpPr>
        <p:spPr>
          <a:xfrm rot="16200000">
            <a:off x="3663977" y="4884952"/>
            <a:ext cx="23092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 err="1"/>
              <a:t>Spermine</a:t>
            </a:r>
            <a:br>
              <a:rPr lang="en-US" altLang="ja-JP" sz="1200" dirty="0"/>
            </a:br>
            <a:r>
              <a:rPr lang="en-US" altLang="ja-JP" sz="1200" dirty="0"/>
              <a:t>(</a:t>
            </a:r>
            <a:r>
              <a:rPr lang="en-US" altLang="ja-JP" sz="1200" dirty="0" err="1"/>
              <a:t>nmol</a:t>
            </a:r>
            <a:r>
              <a:rPr lang="en-US" altLang="ja-JP" sz="1200" dirty="0"/>
              <a:t>/mg of protein)</a:t>
            </a:r>
          </a:p>
        </p:txBody>
      </p:sp>
      <p:sp>
        <p:nvSpPr>
          <p:cNvPr id="75" name="テキスト ボックス 74"/>
          <p:cNvSpPr txBox="1"/>
          <p:nvPr/>
        </p:nvSpPr>
        <p:spPr>
          <a:xfrm rot="16200000">
            <a:off x="1460312" y="4813588"/>
            <a:ext cx="23092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/>
              <a:t>Spermidine</a:t>
            </a:r>
            <a:br>
              <a:rPr lang="en-US" altLang="ja-JP" sz="1200" dirty="0"/>
            </a:br>
            <a:r>
              <a:rPr lang="en-US" altLang="ja-JP" sz="1200" dirty="0"/>
              <a:t>(</a:t>
            </a:r>
            <a:r>
              <a:rPr lang="en-US" altLang="ja-JP" sz="1200" dirty="0" err="1"/>
              <a:t>nmol</a:t>
            </a:r>
            <a:r>
              <a:rPr lang="en-US" altLang="ja-JP" sz="1200" dirty="0"/>
              <a:t>/mg of protein)</a:t>
            </a:r>
          </a:p>
        </p:txBody>
      </p:sp>
      <p:graphicFrame>
        <p:nvGraphicFramePr>
          <p:cNvPr id="33" name="グラフ 32"/>
          <p:cNvGraphicFramePr/>
          <p:nvPr>
            <p:extLst>
              <p:ext uri="{D42A27DB-BD31-4B8C-83A1-F6EECF244321}">
                <p14:modId xmlns:p14="http://schemas.microsoft.com/office/powerpoint/2010/main" val="704556057"/>
              </p:ext>
            </p:extLst>
          </p:nvPr>
        </p:nvGraphicFramePr>
        <p:xfrm>
          <a:off x="4813157" y="4104411"/>
          <a:ext cx="1944000" cy="20227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4" name="表 3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55967920"/>
              </p:ext>
            </p:extLst>
          </p:nvPr>
        </p:nvGraphicFramePr>
        <p:xfrm>
          <a:off x="5332663" y="5841124"/>
          <a:ext cx="1464904" cy="136199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32452">
                  <a:extLst>
                    <a:ext uri="{9D8B030D-6E8A-4147-A177-3AD203B41FA5}">
                      <a16:colId xmlns:a16="http://schemas.microsoft.com/office/drawing/2014/main" val="3189203486"/>
                    </a:ext>
                  </a:extLst>
                </a:gridCol>
                <a:gridCol w="732452">
                  <a:extLst>
                    <a:ext uri="{9D8B030D-6E8A-4147-A177-3AD203B41FA5}">
                      <a16:colId xmlns:a16="http://schemas.microsoft.com/office/drawing/2014/main" val="1391991627"/>
                    </a:ext>
                  </a:extLst>
                </a:gridCol>
              </a:tblGrid>
              <a:tr h="1361997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b="1" baseline="0" dirty="0" err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明朝" panose="02020609040205080304" pitchFamily="17" charset="-128"/>
                          <a:cs typeface="Calibri" panose="020F0502020204030204" pitchFamily="34" charset="0"/>
                        </a:rPr>
                        <a:t>10h</a:t>
                      </a:r>
                      <a:endParaRPr kumimoji="1" lang="en-US" altLang="ja-JP" sz="1400" b="1" baseline="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明朝" panose="02020609040205080304" pitchFamily="17" charset="-128"/>
                        <a:cs typeface="Calibri" panose="020F0502020204030204" pitchFamily="34" charset="0"/>
                      </a:endParaRPr>
                    </a:p>
                  </a:txBody>
                  <a:tcPr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400" dirty="0" err="1">
                          <a:solidFill>
                            <a:schemeClr val="tx1"/>
                          </a:solidFill>
                        </a:rPr>
                        <a:t>30h</a:t>
                      </a:r>
                      <a:r>
                        <a:rPr lang="ja-JP" altLang="en-US" sz="1400" dirty="0">
                          <a:solidFill>
                            <a:schemeClr val="tx1"/>
                          </a:solidFill>
                        </a:rPr>
                        <a:t> </a:t>
                      </a:r>
                      <a:endParaRPr kumimoji="1" lang="ja-JP" altLang="en-US" sz="1400" b="0" baseline="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明朝" panose="02020609040205080304" pitchFamily="17" charset="-128"/>
                        <a:cs typeface="Calibri" panose="020F0502020204030204" pitchFamily="34" charset="0"/>
                      </a:endParaRPr>
                    </a:p>
                  </a:txBody>
                  <a:tcPr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7657269"/>
                  </a:ext>
                </a:extLst>
              </a:tr>
            </a:tbl>
          </a:graphicData>
        </a:graphic>
      </p:graphicFrame>
      <p:graphicFrame>
        <p:nvGraphicFramePr>
          <p:cNvPr id="23" name="グラフ 22"/>
          <p:cNvGraphicFramePr/>
          <p:nvPr>
            <p:extLst>
              <p:ext uri="{D42A27DB-BD31-4B8C-83A1-F6EECF244321}">
                <p14:modId xmlns:p14="http://schemas.microsoft.com/office/powerpoint/2010/main" val="3553514272"/>
              </p:ext>
            </p:extLst>
          </p:nvPr>
        </p:nvGraphicFramePr>
        <p:xfrm>
          <a:off x="350994" y="4152843"/>
          <a:ext cx="1944000" cy="20227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4" name="テキスト ボックス 23"/>
          <p:cNvSpPr txBox="1"/>
          <p:nvPr/>
        </p:nvSpPr>
        <p:spPr>
          <a:xfrm>
            <a:off x="84372" y="3738247"/>
            <a:ext cx="6292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400" dirty="0">
                <a:latin typeface="Calibri" panose="020F050202020403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D</a:t>
            </a:r>
            <a:endParaRPr lang="ja-JP" altLang="en-US" sz="2400" dirty="0">
              <a:latin typeface="Calibri" panose="020F050202020403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 rot="16200000">
            <a:off x="-884006" y="4813587"/>
            <a:ext cx="23092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/>
              <a:t>Putrescine</a:t>
            </a:r>
            <a:br>
              <a:rPr lang="en-US" altLang="ja-JP" sz="1200" dirty="0"/>
            </a:br>
            <a:r>
              <a:rPr lang="en-US" altLang="ja-JP" sz="1200" dirty="0"/>
              <a:t>(</a:t>
            </a:r>
            <a:r>
              <a:rPr lang="en-US" altLang="ja-JP" sz="1200" dirty="0" err="1"/>
              <a:t>nmol</a:t>
            </a:r>
            <a:r>
              <a:rPr lang="en-US" altLang="ja-JP" sz="1200" dirty="0"/>
              <a:t>/mg of protein)</a:t>
            </a:r>
          </a:p>
        </p:txBody>
      </p:sp>
      <p:graphicFrame>
        <p:nvGraphicFramePr>
          <p:cNvPr id="26" name="表 2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13019357"/>
              </p:ext>
            </p:extLst>
          </p:nvPr>
        </p:nvGraphicFramePr>
        <p:xfrm>
          <a:off x="859338" y="5836768"/>
          <a:ext cx="1464904" cy="136199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32452">
                  <a:extLst>
                    <a:ext uri="{9D8B030D-6E8A-4147-A177-3AD203B41FA5}">
                      <a16:colId xmlns:a16="http://schemas.microsoft.com/office/drawing/2014/main" val="3189203486"/>
                    </a:ext>
                  </a:extLst>
                </a:gridCol>
                <a:gridCol w="732452">
                  <a:extLst>
                    <a:ext uri="{9D8B030D-6E8A-4147-A177-3AD203B41FA5}">
                      <a16:colId xmlns:a16="http://schemas.microsoft.com/office/drawing/2014/main" val="1391991627"/>
                    </a:ext>
                  </a:extLst>
                </a:gridCol>
              </a:tblGrid>
              <a:tr h="1361997"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b="1" baseline="0" dirty="0" err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明朝" panose="02020609040205080304" pitchFamily="17" charset="-128"/>
                          <a:cs typeface="Calibri" panose="020F0502020204030204" pitchFamily="34" charset="0"/>
                        </a:rPr>
                        <a:t>10h</a:t>
                      </a:r>
                      <a:endParaRPr kumimoji="1" lang="en-US" altLang="ja-JP" sz="1400" b="1" baseline="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明朝" panose="02020609040205080304" pitchFamily="17" charset="-128"/>
                        <a:cs typeface="Calibri" panose="020F0502020204030204" pitchFamily="34" charset="0"/>
                      </a:endParaRPr>
                    </a:p>
                  </a:txBody>
                  <a:tcPr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400" dirty="0" err="1">
                          <a:solidFill>
                            <a:schemeClr val="tx1"/>
                          </a:solidFill>
                        </a:rPr>
                        <a:t>30h</a:t>
                      </a:r>
                      <a:r>
                        <a:rPr lang="ja-JP" altLang="en-US" sz="1400" dirty="0">
                          <a:solidFill>
                            <a:schemeClr val="tx1"/>
                          </a:solidFill>
                        </a:rPr>
                        <a:t> </a:t>
                      </a:r>
                      <a:endParaRPr kumimoji="1" lang="ja-JP" altLang="en-US" sz="1400" b="0" baseline="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明朝" panose="02020609040205080304" pitchFamily="17" charset="-128"/>
                        <a:cs typeface="Calibri" panose="020F0502020204030204" pitchFamily="34" charset="0"/>
                      </a:endParaRPr>
                    </a:p>
                  </a:txBody>
                  <a:tcPr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765726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99716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73527" y="0"/>
            <a:ext cx="152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solidFill>
                  <a:srgbClr val="FF0000"/>
                </a:solidFill>
                <a:latin typeface="Calibri" panose="020F0502020204030204" pitchFamily="34" charset="0"/>
              </a:rPr>
              <a:t>Figure S3</a:t>
            </a:r>
            <a:endParaRPr kumimoji="1" lang="ja-JP" altLang="en-US" sz="1600" dirty="0">
              <a:solidFill>
                <a:srgbClr val="FF0000"/>
              </a:solidFill>
              <a:latin typeface="Calibri" panose="020F0502020204030204" pitchFamily="34" charset="0"/>
            </a:endParaRPr>
          </a:p>
        </p:txBody>
      </p:sp>
      <p:grpSp>
        <p:nvGrpSpPr>
          <p:cNvPr id="11" name="グループ化 10"/>
          <p:cNvGrpSpPr/>
          <p:nvPr/>
        </p:nvGrpSpPr>
        <p:grpSpPr>
          <a:xfrm>
            <a:off x="213070" y="780749"/>
            <a:ext cx="6277620" cy="3246184"/>
            <a:chOff x="95503" y="780749"/>
            <a:chExt cx="6277620" cy="3246184"/>
          </a:xfrm>
        </p:grpSpPr>
        <p:graphicFrame>
          <p:nvGraphicFramePr>
            <p:cNvPr id="5" name="グラフ 4"/>
            <p:cNvGraphicFramePr/>
            <p:nvPr>
              <p:extLst>
                <p:ext uri="{D42A27DB-BD31-4B8C-83A1-F6EECF244321}">
                  <p14:modId xmlns:p14="http://schemas.microsoft.com/office/powerpoint/2010/main" val="2293456490"/>
                </p:ext>
              </p:extLst>
            </p:nvPr>
          </p:nvGraphicFramePr>
          <p:xfrm>
            <a:off x="464835" y="780749"/>
            <a:ext cx="5908288" cy="295522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" name="テキスト ボックス 14"/>
            <p:cNvSpPr txBox="1"/>
            <p:nvPr/>
          </p:nvSpPr>
          <p:spPr>
            <a:xfrm rot="16200000">
              <a:off x="-341199" y="1864692"/>
              <a:ext cx="12427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1800" dirty="0"/>
                <a:t>OD</a:t>
              </a:r>
              <a:r>
                <a:rPr lang="en-US" altLang="ja-JP" sz="1800" baseline="-25000" dirty="0"/>
                <a:t>600</a:t>
              </a:r>
            </a:p>
          </p:txBody>
        </p:sp>
        <p:sp>
          <p:nvSpPr>
            <p:cNvPr id="7" name="テキスト ボックス 14"/>
            <p:cNvSpPr txBox="1"/>
            <p:nvPr/>
          </p:nvSpPr>
          <p:spPr>
            <a:xfrm>
              <a:off x="1479960" y="3657601"/>
              <a:ext cx="364290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1800" dirty="0"/>
                <a:t>Ornithine supplementation (</a:t>
              </a:r>
              <a:r>
                <a:rPr lang="en-US" altLang="ja-JP" sz="1800" dirty="0" err="1"/>
                <a:t>mM</a:t>
              </a:r>
              <a:r>
                <a:rPr lang="en-US" altLang="ja-JP" sz="1800" dirty="0"/>
                <a:t>)</a:t>
              </a:r>
            </a:p>
          </p:txBody>
        </p:sp>
      </p:grpSp>
      <p:grpSp>
        <p:nvGrpSpPr>
          <p:cNvPr id="12" name="グループ化 11"/>
          <p:cNvGrpSpPr/>
          <p:nvPr/>
        </p:nvGrpSpPr>
        <p:grpSpPr>
          <a:xfrm>
            <a:off x="82440" y="4111774"/>
            <a:ext cx="6401622" cy="3246184"/>
            <a:chOff x="297708" y="4538505"/>
            <a:chExt cx="6201689" cy="3246184"/>
          </a:xfrm>
        </p:grpSpPr>
        <p:graphicFrame>
          <p:nvGraphicFramePr>
            <p:cNvPr id="8" name="グラフ 7"/>
            <p:cNvGraphicFramePr/>
            <p:nvPr>
              <p:extLst>
                <p:ext uri="{D42A27DB-BD31-4B8C-83A1-F6EECF244321}">
                  <p14:modId xmlns:p14="http://schemas.microsoft.com/office/powerpoint/2010/main" val="4120157139"/>
                </p:ext>
              </p:extLst>
            </p:nvPr>
          </p:nvGraphicFramePr>
          <p:xfrm>
            <a:off x="591109" y="4538505"/>
            <a:ext cx="5908288" cy="295522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9" name="テキスト ボックス 14"/>
            <p:cNvSpPr txBox="1"/>
            <p:nvPr/>
          </p:nvSpPr>
          <p:spPr>
            <a:xfrm rot="16200000">
              <a:off x="-549700" y="5798019"/>
              <a:ext cx="20641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1800" dirty="0"/>
                <a:t>Putrescine (</a:t>
              </a:r>
              <a:r>
                <a:rPr lang="en-US" altLang="ja-JP" sz="1800" dirty="0" err="1"/>
                <a:t>mM</a:t>
              </a:r>
              <a:r>
                <a:rPr lang="en-US" altLang="ja-JP" sz="1800" dirty="0"/>
                <a:t>)</a:t>
              </a:r>
            </a:p>
          </p:txBody>
        </p:sp>
        <p:sp>
          <p:nvSpPr>
            <p:cNvPr id="10" name="テキスト ボックス 14"/>
            <p:cNvSpPr txBox="1"/>
            <p:nvPr/>
          </p:nvSpPr>
          <p:spPr>
            <a:xfrm>
              <a:off x="1694819" y="7415357"/>
              <a:ext cx="364290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1800" dirty="0"/>
                <a:t>Ornithine supplementation (</a:t>
              </a:r>
              <a:r>
                <a:rPr lang="en-US" altLang="ja-JP" sz="1800" dirty="0" err="1"/>
                <a:t>mM</a:t>
              </a:r>
              <a:r>
                <a:rPr lang="en-US" altLang="ja-JP" sz="1800" dirty="0"/>
                <a:t>)</a:t>
              </a:r>
            </a:p>
          </p:txBody>
        </p:sp>
      </p:grpSp>
      <p:sp>
        <p:nvSpPr>
          <p:cNvPr id="13" name="テキスト ボックス 6">
            <a:extLst>
              <a:ext uri="{FF2B5EF4-FFF2-40B4-BE49-F238E27FC236}">
                <a16:creationId xmlns:a16="http://schemas.microsoft.com/office/drawing/2014/main" id="{585094F6-EB44-46E0-AAD2-AAA39D747B36}"/>
              </a:ext>
            </a:extLst>
          </p:cNvPr>
          <p:cNvSpPr txBox="1"/>
          <p:nvPr/>
        </p:nvSpPr>
        <p:spPr>
          <a:xfrm>
            <a:off x="114300" y="580878"/>
            <a:ext cx="390406" cy="46534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just">
              <a:spcAft>
                <a:spcPts val="0"/>
              </a:spcAft>
            </a:pPr>
            <a:r>
              <a:rPr lang="en-US" altLang="ja-JP" sz="2400" dirty="0">
                <a:effectLst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A</a:t>
            </a:r>
            <a:endParaRPr lang="ja-JP" sz="2400" dirty="0">
              <a:effectLst/>
              <a:ea typeface="ＭＳ Ｐゴシック" panose="020B0600070205080204" pitchFamily="50" charset="-128"/>
              <a:cs typeface="ＭＳ Ｐゴシック" panose="020B0600070205080204" pitchFamily="50" charset="-128"/>
            </a:endParaRPr>
          </a:p>
        </p:txBody>
      </p:sp>
      <p:sp>
        <p:nvSpPr>
          <p:cNvPr id="14" name="テキスト ボックス 6">
            <a:extLst>
              <a:ext uri="{FF2B5EF4-FFF2-40B4-BE49-F238E27FC236}">
                <a16:creationId xmlns:a16="http://schemas.microsoft.com/office/drawing/2014/main" id="{E64EDF42-B6A3-4FB8-AF74-C1E2C4D3046F}"/>
              </a:ext>
            </a:extLst>
          </p:cNvPr>
          <p:cNvSpPr txBox="1"/>
          <p:nvPr/>
        </p:nvSpPr>
        <p:spPr>
          <a:xfrm>
            <a:off x="118416" y="3905670"/>
            <a:ext cx="390406" cy="46534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just">
              <a:spcAft>
                <a:spcPts val="0"/>
              </a:spcAft>
            </a:pPr>
            <a:r>
              <a:rPr lang="en-US" altLang="ja-JP" sz="2400" dirty="0"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B</a:t>
            </a:r>
            <a:endParaRPr lang="ja-JP" sz="2400" dirty="0">
              <a:effectLst/>
              <a:ea typeface="ＭＳ Ｐゴシック" panose="020B0600070205080204" pitchFamily="50" charset="-128"/>
              <a:cs typeface="ＭＳ Ｐゴシック" panose="020B060007020508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41712679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9276" y="498808"/>
            <a:ext cx="5960923" cy="866460"/>
          </a:xfrm>
          <a:prstGeom prst="rect">
            <a:avLst/>
          </a:prstGeom>
        </p:spPr>
      </p:pic>
      <p:sp>
        <p:nvSpPr>
          <p:cNvPr id="5" name="テキスト ボックス 6"/>
          <p:cNvSpPr txBox="1"/>
          <p:nvPr/>
        </p:nvSpPr>
        <p:spPr>
          <a:xfrm>
            <a:off x="0" y="85578"/>
            <a:ext cx="390406" cy="46534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just">
              <a:spcAft>
                <a:spcPts val="0"/>
              </a:spcAft>
            </a:pPr>
            <a:r>
              <a:rPr lang="en-US" altLang="ja-JP" sz="2400" dirty="0">
                <a:effectLst/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A</a:t>
            </a:r>
            <a:endParaRPr lang="ja-JP" sz="2400" dirty="0">
              <a:effectLst/>
              <a:ea typeface="ＭＳ Ｐゴシック" panose="020B0600070205080204" pitchFamily="50" charset="-128"/>
              <a:cs typeface="ＭＳ Ｐゴシック" panose="020B0600070205080204" pitchFamily="50" charset="-128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0" y="-66170"/>
            <a:ext cx="152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solidFill>
                  <a:srgbClr val="FF0000"/>
                </a:solidFill>
                <a:latin typeface="Calibri" panose="020F0502020204030204" pitchFamily="34" charset="0"/>
              </a:rPr>
              <a:t>Figure S4</a:t>
            </a:r>
            <a:endParaRPr kumimoji="1" lang="ja-JP" altLang="en-US" sz="1600" dirty="0">
              <a:solidFill>
                <a:srgbClr val="FF0000"/>
              </a:solidFill>
              <a:latin typeface="Calibri" panose="020F050202020403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408665" y="1355308"/>
            <a:ext cx="2286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KP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3-4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263859" y="314643"/>
            <a:ext cx="2286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NZ_CP026116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6"/>
          <p:cNvSpPr txBox="1"/>
          <p:nvPr/>
        </p:nvSpPr>
        <p:spPr>
          <a:xfrm>
            <a:off x="4116" y="1794930"/>
            <a:ext cx="390406" cy="46534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just">
              <a:spcAft>
                <a:spcPts val="0"/>
              </a:spcAft>
            </a:pPr>
            <a:r>
              <a:rPr lang="en-US" altLang="ja-JP" sz="2400" dirty="0">
                <a:ea typeface="ＭＳ Ｐゴシック" panose="020B0600070205080204" pitchFamily="50" charset="-128"/>
                <a:cs typeface="ＭＳ Ｐゴシック" panose="020B0600070205080204" pitchFamily="50" charset="-128"/>
              </a:rPr>
              <a:t>B</a:t>
            </a:r>
            <a:endParaRPr lang="ja-JP" sz="2400" dirty="0">
              <a:effectLst/>
              <a:ea typeface="ＭＳ Ｐゴシック" panose="020B0600070205080204" pitchFamily="50" charset="-128"/>
              <a:cs typeface="ＭＳ Ｐゴシック" panose="020B0600070205080204" pitchFamily="50" charset="-128"/>
            </a:endParaRPr>
          </a:p>
        </p:txBody>
      </p:sp>
      <p:cxnSp>
        <p:nvCxnSpPr>
          <p:cNvPr id="9" name="直線コネクタ 8"/>
          <p:cNvCxnSpPr/>
          <p:nvPr/>
        </p:nvCxnSpPr>
        <p:spPr>
          <a:xfrm flipV="1">
            <a:off x="587786" y="2654809"/>
            <a:ext cx="5652000" cy="6339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右矢印 9"/>
          <p:cNvSpPr>
            <a:spLocks/>
          </p:cNvSpPr>
          <p:nvPr/>
        </p:nvSpPr>
        <p:spPr>
          <a:xfrm>
            <a:off x="1493284" y="2336475"/>
            <a:ext cx="2484000" cy="648000"/>
          </a:xfrm>
          <a:prstGeom prst="rightArrow">
            <a:avLst/>
          </a:prstGeom>
          <a:solidFill>
            <a:srgbClr val="FFFF00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右矢印 13"/>
          <p:cNvSpPr>
            <a:spLocks/>
          </p:cNvSpPr>
          <p:nvPr/>
        </p:nvSpPr>
        <p:spPr>
          <a:xfrm>
            <a:off x="4265776" y="2341951"/>
            <a:ext cx="1692000" cy="648000"/>
          </a:xfrm>
          <a:prstGeom prst="rightArrow">
            <a:avLst/>
          </a:prstGeom>
          <a:solidFill>
            <a:srgbClr val="FFCCFF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4629076" y="2487734"/>
            <a:ext cx="7076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i="1" dirty="0" err="1"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potE</a:t>
            </a:r>
            <a:endParaRPr lang="en-US" altLang="ja-JP" sz="1200" dirty="0">
              <a:latin typeface="ＭＳ Ｐゴシック" panose="020B0600070205080204" pitchFamily="50" charset="-128"/>
              <a:ea typeface="ＭＳ Ｐゴシック" panose="020B0600070205080204" pitchFamily="50" charset="-128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2040926" y="2487734"/>
            <a:ext cx="11510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i="1" dirty="0" err="1"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speF</a:t>
            </a:r>
            <a:r>
              <a:rPr lang="en-US" altLang="ja-JP" sz="1200" dirty="0"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/</a:t>
            </a:r>
            <a:r>
              <a:rPr lang="en-US" altLang="ja-JP" sz="1200" i="1" dirty="0" err="1"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speC</a:t>
            </a:r>
            <a:endParaRPr lang="en-US" altLang="ja-JP" sz="1200" i="1" dirty="0">
              <a:latin typeface="ＭＳ Ｐゴシック" panose="020B0600070205080204" pitchFamily="50" charset="-128"/>
              <a:ea typeface="ＭＳ Ｐゴシック" panose="020B0600070205080204" pitchFamily="50" charset="-128"/>
            </a:endParaRPr>
          </a:p>
        </p:txBody>
      </p:sp>
      <p:sp>
        <p:nvSpPr>
          <p:cNvPr id="2" name="正方形/長方形 1"/>
          <p:cNvSpPr/>
          <p:nvPr/>
        </p:nvSpPr>
        <p:spPr>
          <a:xfrm>
            <a:off x="-27933" y="2669860"/>
            <a:ext cx="76014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/>
              <a:t>1,279,295</a:t>
            </a:r>
            <a:endParaRPr lang="ja-JP" altLang="en-US" sz="1100" dirty="0"/>
          </a:p>
        </p:txBody>
      </p:sp>
      <p:sp>
        <p:nvSpPr>
          <p:cNvPr id="18" name="正方形/長方形 17"/>
          <p:cNvSpPr/>
          <p:nvPr/>
        </p:nvSpPr>
        <p:spPr>
          <a:xfrm>
            <a:off x="6034731" y="2650744"/>
            <a:ext cx="76014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/>
              <a:t>1,284,881</a:t>
            </a:r>
            <a:endParaRPr lang="ja-JP" altLang="en-US" sz="1100" dirty="0"/>
          </a:p>
        </p:txBody>
      </p:sp>
      <p:cxnSp>
        <p:nvCxnSpPr>
          <p:cNvPr id="20" name="直線コネクタ 19"/>
          <p:cNvCxnSpPr/>
          <p:nvPr/>
        </p:nvCxnSpPr>
        <p:spPr>
          <a:xfrm>
            <a:off x="3968884" y="2373920"/>
            <a:ext cx="0" cy="900000"/>
          </a:xfrm>
          <a:prstGeom prst="line">
            <a:avLst/>
          </a:prstGeom>
          <a:ln w="38100">
            <a:solidFill>
              <a:srgbClr val="7F7F7F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/>
          <p:cNvCxnSpPr/>
          <p:nvPr/>
        </p:nvCxnSpPr>
        <p:spPr>
          <a:xfrm>
            <a:off x="1483759" y="2373920"/>
            <a:ext cx="0" cy="900000"/>
          </a:xfrm>
          <a:prstGeom prst="line">
            <a:avLst/>
          </a:prstGeom>
          <a:ln w="38100">
            <a:solidFill>
              <a:srgbClr val="7F7F7F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正方形/長方形 23"/>
          <p:cNvSpPr/>
          <p:nvPr/>
        </p:nvSpPr>
        <p:spPr>
          <a:xfrm>
            <a:off x="3415481" y="3249805"/>
            <a:ext cx="76014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/>
              <a:t>1,283,395</a:t>
            </a:r>
            <a:endParaRPr lang="ja-JP" altLang="en-US" sz="1100" dirty="0"/>
          </a:p>
        </p:txBody>
      </p:sp>
      <p:sp>
        <p:nvSpPr>
          <p:cNvPr id="26" name="正方形/長方形 25"/>
          <p:cNvSpPr/>
          <p:nvPr/>
        </p:nvSpPr>
        <p:spPr>
          <a:xfrm>
            <a:off x="964855" y="3258805"/>
            <a:ext cx="76014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/>
              <a:t>1,281,281</a:t>
            </a:r>
            <a:endParaRPr lang="ja-JP" altLang="en-US" sz="1100" dirty="0"/>
          </a:p>
        </p:txBody>
      </p:sp>
      <p:cxnSp>
        <p:nvCxnSpPr>
          <p:cNvPr id="27" name="直線コネクタ 26"/>
          <p:cNvCxnSpPr/>
          <p:nvPr/>
        </p:nvCxnSpPr>
        <p:spPr>
          <a:xfrm>
            <a:off x="4242214" y="2373920"/>
            <a:ext cx="0" cy="1152000"/>
          </a:xfrm>
          <a:prstGeom prst="line">
            <a:avLst/>
          </a:prstGeom>
          <a:ln w="38100">
            <a:solidFill>
              <a:srgbClr val="7F7F7F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正方形/長方形 28"/>
          <p:cNvSpPr/>
          <p:nvPr/>
        </p:nvSpPr>
        <p:spPr>
          <a:xfrm>
            <a:off x="3865849" y="3516860"/>
            <a:ext cx="76014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/>
              <a:t>1,283,497</a:t>
            </a:r>
            <a:endParaRPr lang="ja-JP" altLang="en-US" sz="1100" dirty="0"/>
          </a:p>
        </p:txBody>
      </p:sp>
      <p:sp>
        <p:nvSpPr>
          <p:cNvPr id="33" name="正方形/長方形 32"/>
          <p:cNvSpPr/>
          <p:nvPr/>
        </p:nvSpPr>
        <p:spPr>
          <a:xfrm>
            <a:off x="5572538" y="3516860"/>
            <a:ext cx="76014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/>
              <a:t>1,284,795</a:t>
            </a:r>
            <a:endParaRPr lang="ja-JP" altLang="en-US" sz="1100" dirty="0"/>
          </a:p>
        </p:txBody>
      </p:sp>
      <p:cxnSp>
        <p:nvCxnSpPr>
          <p:cNvPr id="34" name="直線コネクタ 33"/>
          <p:cNvCxnSpPr/>
          <p:nvPr/>
        </p:nvCxnSpPr>
        <p:spPr>
          <a:xfrm>
            <a:off x="5948579" y="2373920"/>
            <a:ext cx="0" cy="1152000"/>
          </a:xfrm>
          <a:prstGeom prst="line">
            <a:avLst/>
          </a:prstGeom>
          <a:ln w="38100">
            <a:solidFill>
              <a:srgbClr val="7F7F7F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正方形/長方形 40"/>
          <p:cNvSpPr/>
          <p:nvPr/>
        </p:nvSpPr>
        <p:spPr>
          <a:xfrm>
            <a:off x="4281752" y="2931382"/>
            <a:ext cx="1701738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dirty="0"/>
              <a:t>64% amino acid sequence </a:t>
            </a:r>
            <a:br>
              <a:rPr lang="en-US" altLang="ja-JP" sz="1100" dirty="0"/>
            </a:br>
            <a:r>
              <a:rPr lang="en-US" altLang="ja-JP" sz="1100" dirty="0"/>
              <a:t>identity to </a:t>
            </a:r>
            <a:r>
              <a:rPr lang="en-US" altLang="ja-JP" sz="1100" dirty="0" err="1"/>
              <a:t>PotE</a:t>
            </a:r>
            <a:r>
              <a:rPr lang="en-US" altLang="ja-JP" sz="1100" dirty="0"/>
              <a:t> in </a:t>
            </a:r>
            <a:r>
              <a:rPr lang="en-US" altLang="ja-JP" sz="1100" i="1" dirty="0"/>
              <a:t>E. coli</a:t>
            </a:r>
            <a:r>
              <a:rPr lang="en-US" altLang="ja-JP" sz="1100" dirty="0"/>
              <a:t>.</a:t>
            </a:r>
            <a:endParaRPr lang="ja-JP" altLang="en-US" sz="1100" dirty="0"/>
          </a:p>
        </p:txBody>
      </p:sp>
      <p:sp>
        <p:nvSpPr>
          <p:cNvPr id="42" name="正方形/長方形 41"/>
          <p:cNvSpPr/>
          <p:nvPr/>
        </p:nvSpPr>
        <p:spPr>
          <a:xfrm>
            <a:off x="1800555" y="2867882"/>
            <a:ext cx="1701738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dirty="0"/>
              <a:t>56% and 55% amino acid sequence identity to </a:t>
            </a:r>
            <a:r>
              <a:rPr lang="en-US" altLang="ja-JP" sz="1100" dirty="0" err="1"/>
              <a:t>SpeF</a:t>
            </a:r>
            <a:r>
              <a:rPr lang="en-US" altLang="ja-JP" sz="1100" dirty="0"/>
              <a:t> and </a:t>
            </a:r>
            <a:r>
              <a:rPr lang="en-US" altLang="ja-JP" sz="1100" dirty="0" err="1"/>
              <a:t>SpeC</a:t>
            </a:r>
            <a:r>
              <a:rPr lang="en-US" altLang="ja-JP" sz="1100" dirty="0"/>
              <a:t> in </a:t>
            </a:r>
            <a:r>
              <a:rPr lang="en-US" altLang="ja-JP" sz="1100" i="1" dirty="0"/>
              <a:t>E. coli, </a:t>
            </a:r>
            <a:r>
              <a:rPr lang="en-US" altLang="ja-JP" sz="1100" dirty="0"/>
              <a:t>respectively.</a:t>
            </a:r>
            <a:endParaRPr lang="ja-JP" altLang="en-US" sz="1100" dirty="0"/>
          </a:p>
        </p:txBody>
      </p:sp>
    </p:spTree>
    <p:extLst>
      <p:ext uri="{BB962C8B-B14F-4D97-AF65-F5344CB8AC3E}">
        <p14:creationId xmlns:p14="http://schemas.microsoft.com/office/powerpoint/2010/main" val="25288440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520</TotalTime>
  <Words>265</Words>
  <Application>Microsoft Office PowerPoint</Application>
  <PresentationFormat>A4 Paper (210x297 mm)</PresentationFormat>
  <Paragraphs>86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ＭＳ Ｐゴシック</vt:lpstr>
      <vt:lpstr>Arial</vt:lpstr>
      <vt:lpstr>Calibri</vt:lpstr>
      <vt:lpstr>Calibri Light</vt:lpstr>
      <vt:lpstr>Office テーマ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uta Sugiyama</dc:creator>
  <cp:lastModifiedBy>MDPI-61</cp:lastModifiedBy>
  <cp:revision>497</cp:revision>
  <cp:lastPrinted>2022-02-16T11:36:16Z</cp:lastPrinted>
  <dcterms:created xsi:type="dcterms:W3CDTF">2017-09-15T02:31:27Z</dcterms:created>
  <dcterms:modified xsi:type="dcterms:W3CDTF">2022-03-15T10:37:18Z</dcterms:modified>
</cp:coreProperties>
</file>